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2" r:id="rId3"/>
    <p:sldId id="263" r:id="rId4"/>
    <p:sldId id="257" r:id="rId5"/>
    <p:sldId id="264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107" autoAdjust="0"/>
    <p:restoredTop sz="94660"/>
  </p:normalViewPr>
  <p:slideViewPr>
    <p:cSldViewPr snapToGrid="0">
      <p:cViewPr varScale="1">
        <p:scale>
          <a:sx n="67" d="100"/>
          <a:sy n="67" d="100"/>
        </p:scale>
        <p:origin x="676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040243B-C9D9-4E37-8A9B-975BA07140B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DA714692-240B-41C5-8C90-F164BAD8D7C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B9EF380-C5C3-4129-8EEE-D4E623AC83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7BB1000-A6C0-4C62-B2EA-1FD1D97838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5E3F364-DC77-44FD-8491-23302B6B04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06171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8F54C79-CE91-4E61-8E4D-D33854ED0B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6DFD16E-473E-4D8B-A930-A65036E800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77A1B09-20F6-48E8-B7A4-59C60E4C61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3D38E91-8B3C-42C4-81BA-2A528F65A3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78CFB91-036B-455E-ADB7-9BCA99A456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97556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BAF64375-249E-4A22-B075-930765B1568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0D4BDBB-E397-401F-81CC-ACD122A422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6B2B769-92F2-4A7C-A9AE-92647EE79C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B978F82-22F3-4700-905C-B8BF30FA6A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8A028F0-7A7E-4402-8B38-E013B57CE3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09455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2D32A81-633D-4770-80E3-A7A9DDD1B4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C7CBB39-00E4-41AC-A959-E946ABF615C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6656EC8-08E9-44FD-BCFA-0F41EB3195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F44FEB1-A99B-445C-9FDD-26525761A8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D1EB348-1246-4E52-9BF8-63186A6036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85705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C2F3AAD-9A47-4021-9DD9-6228DA476D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704A4F6-104B-419C-BB48-F4C993E0F8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6BA6A41-D01F-42A5-A0CB-C3858E782B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1B6E1E1-1D4E-46ED-ABE7-9809687FEE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DCF9A44-A457-4832-BF3D-DD4F4B1600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94523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DDFBED2-9502-4A6E-9B63-6FD5D4C813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838064D-07F7-4F1C-B27F-2EBBE2CB195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0ADBD82-67F9-480E-9432-3763B19B37A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D2A9A7C-C81A-4CA4-975E-A60478CCD3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D52C19B-593E-4BA2-BB98-C13F532859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F69C6D4-056C-4CB7-A498-2298945DB2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775110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232F730-5371-47F1-B409-A5EA0A7D76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17530FC-E9BF-4073-8401-C6C23EF02B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0936AD0-1C01-439A-B5AA-D0CF7C96CD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A027F032-1417-4983-B5B7-DBC3D6FFD94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81EC7F1C-5D7C-4352-B083-8B2D581E6DF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D578B67B-AF5E-4672-9A72-D4789F00BF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B85725B8-1C48-419D-B7F3-8927ABCAAC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82102D0-C63F-4A18-A7D1-BA31B9A895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6365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E659908-829A-456D-96A3-24686DDA2F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3A86B67D-AF34-4215-A1F8-513DA47174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600DA581-5376-4789-9A85-EE2D12191B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3AB3051E-C5C3-47E4-A22A-EB298DC97F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97172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02BEF6F9-93DC-4307-9D39-F0E43AF5A7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ED19725D-91E4-4FEE-8026-BE495B9B6D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6FA0E68-5D0B-4062-AD51-69B71FEFA3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55522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3426F6B-2031-490C-A5A1-65A46833B0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25BFA83-4F0E-48B7-A0D0-99003B02597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635C5ED-0C58-4A9C-AFAC-BDAC71E895E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0E7E3A4-5DDB-4572-BEE1-ADA34AA13F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EC9AD49-1057-4906-AD26-A3BF50F48E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4353386-48BC-441A-AF4F-EA28190F8A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232939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94EF8F9-F59E-4069-8FE5-2FE2FE57F4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62A3F154-31B2-4BEE-94E9-6B8D74BAAF0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C1A9FAF-7263-4725-A1FD-9E39D8EFA0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C23A9AF-2003-4B75-81D2-AA19AE85AF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F697D45-5293-4E16-AD0B-CFCBA799F8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6DA7F62-83E4-4285-8BB4-718119A4D6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624791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346B0D66-E7A9-404C-802C-1EBC6B2DEF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63C41F8-CAC3-4F72-B536-F69A4C9D7F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C62B3CA-E3A6-4CCE-9F05-A2E288C4AB6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05B4F2E-532A-4F73-B9F5-358176767DC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9FCDDD7-43F4-42EC-A33C-A6605D46191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61417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13" Type="http://schemas.openxmlformats.org/officeDocument/2006/relationships/image" Target="../media/image24.png"/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12" Type="http://schemas.openxmlformats.org/officeDocument/2006/relationships/image" Target="../media/image23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7.png"/><Relationship Id="rId11" Type="http://schemas.openxmlformats.org/officeDocument/2006/relationships/image" Target="../media/image22.png"/><Relationship Id="rId5" Type="http://schemas.openxmlformats.org/officeDocument/2006/relationships/image" Target="../media/image16.png"/><Relationship Id="rId10" Type="http://schemas.openxmlformats.org/officeDocument/2006/relationships/image" Target="../media/image21.png"/><Relationship Id="rId4" Type="http://schemas.openxmlformats.org/officeDocument/2006/relationships/image" Target="../media/image15.png"/><Relationship Id="rId9" Type="http://schemas.openxmlformats.org/officeDocument/2006/relationships/image" Target="../media/image20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png"/><Relationship Id="rId13" Type="http://schemas.openxmlformats.org/officeDocument/2006/relationships/image" Target="../media/image36.png"/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12" Type="http://schemas.openxmlformats.org/officeDocument/2006/relationships/image" Target="../media/image35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9.png"/><Relationship Id="rId11" Type="http://schemas.openxmlformats.org/officeDocument/2006/relationships/image" Target="../media/image34.png"/><Relationship Id="rId5" Type="http://schemas.openxmlformats.org/officeDocument/2006/relationships/image" Target="../media/image28.png"/><Relationship Id="rId10" Type="http://schemas.openxmlformats.org/officeDocument/2006/relationships/image" Target="../media/image33.png"/><Relationship Id="rId4" Type="http://schemas.openxmlformats.org/officeDocument/2006/relationships/image" Target="../media/image27.png"/><Relationship Id="rId9" Type="http://schemas.openxmlformats.org/officeDocument/2006/relationships/image" Target="../media/image32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png"/><Relationship Id="rId13" Type="http://schemas.openxmlformats.org/officeDocument/2006/relationships/image" Target="../media/image48.png"/><Relationship Id="rId3" Type="http://schemas.openxmlformats.org/officeDocument/2006/relationships/image" Target="../media/image38.png"/><Relationship Id="rId7" Type="http://schemas.openxmlformats.org/officeDocument/2006/relationships/image" Target="../media/image42.png"/><Relationship Id="rId12" Type="http://schemas.openxmlformats.org/officeDocument/2006/relationships/image" Target="../media/image47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1.png"/><Relationship Id="rId11" Type="http://schemas.openxmlformats.org/officeDocument/2006/relationships/image" Target="../media/image46.png"/><Relationship Id="rId5" Type="http://schemas.openxmlformats.org/officeDocument/2006/relationships/image" Target="../media/image40.png"/><Relationship Id="rId10" Type="http://schemas.openxmlformats.org/officeDocument/2006/relationships/image" Target="../media/image45.png"/><Relationship Id="rId4" Type="http://schemas.openxmlformats.org/officeDocument/2006/relationships/image" Target="../media/image39.png"/><Relationship Id="rId9" Type="http://schemas.openxmlformats.org/officeDocument/2006/relationships/image" Target="../media/image44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55.tiff"/><Relationship Id="rId3" Type="http://schemas.openxmlformats.org/officeDocument/2006/relationships/image" Target="../media/image50.tiff"/><Relationship Id="rId7" Type="http://schemas.openxmlformats.org/officeDocument/2006/relationships/image" Target="../media/image54.tiff"/><Relationship Id="rId2" Type="http://schemas.openxmlformats.org/officeDocument/2006/relationships/image" Target="../media/image49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3.tiff"/><Relationship Id="rId5" Type="http://schemas.openxmlformats.org/officeDocument/2006/relationships/image" Target="../media/image52.tiff"/><Relationship Id="rId4" Type="http://schemas.openxmlformats.org/officeDocument/2006/relationships/image" Target="../media/image51.tiff"/><Relationship Id="rId9" Type="http://schemas.openxmlformats.org/officeDocument/2006/relationships/image" Target="../media/image5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C76EE6B4-FAF4-45AD-8965-1C8C1CC7A911}"/>
              </a:ext>
            </a:extLst>
          </p:cNvPr>
          <p:cNvSpPr txBox="1"/>
          <p:nvPr/>
        </p:nvSpPr>
        <p:spPr>
          <a:xfrm>
            <a:off x="70386" y="5667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 3E</a:t>
            </a:r>
            <a:endParaRPr lang="zh-CN" altLang="en-US" dirty="0"/>
          </a:p>
        </p:txBody>
      </p:sp>
      <p:pic>
        <p:nvPicPr>
          <p:cNvPr id="19" name="图形 5">
            <a:extLst>
              <a:ext uri="{FF2B5EF4-FFF2-40B4-BE49-F238E27FC236}">
                <a16:creationId xmlns:a16="http://schemas.microsoft.com/office/drawing/2014/main" id="{D371B848-3C68-4C40-B0B6-9B831D35251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34792" y="1753658"/>
            <a:ext cx="1025642" cy="1025356"/>
          </a:xfrm>
          <a:custGeom>
            <a:avLst/>
            <a:gdLst>
              <a:gd name="connsiteX0" fmla="*/ 185 w 1025642"/>
              <a:gd name="connsiteY0" fmla="*/ -168 h 1025356"/>
              <a:gd name="connsiteX1" fmla="*/ 1025827 w 1025642"/>
              <a:gd name="connsiteY1" fmla="*/ -168 h 1025356"/>
              <a:gd name="connsiteX2" fmla="*/ 1025827 w 1025642"/>
              <a:gd name="connsiteY2" fmla="*/ 1025189 h 1025356"/>
              <a:gd name="connsiteX3" fmla="*/ 185 w 1025642"/>
              <a:gd name="connsiteY3" fmla="*/ 1025189 h 102535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25642" h="1025356">
                <a:moveTo>
                  <a:pt x="185" y="-168"/>
                </a:moveTo>
                <a:lnTo>
                  <a:pt x="1025827" y="-168"/>
                </a:lnTo>
                <a:lnTo>
                  <a:pt x="1025827" y="1025189"/>
                </a:lnTo>
                <a:lnTo>
                  <a:pt x="185" y="1025189"/>
                </a:lnTo>
                <a:close/>
              </a:path>
            </a:pathLst>
          </a:custGeom>
        </p:spPr>
      </p:pic>
      <p:pic>
        <p:nvPicPr>
          <p:cNvPr id="20" name="图形 5">
            <a:extLst>
              <a:ext uri="{FF2B5EF4-FFF2-40B4-BE49-F238E27FC236}">
                <a16:creationId xmlns:a16="http://schemas.microsoft.com/office/drawing/2014/main" id="{D371B848-3C68-4C40-B0B6-9B831D35251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34792" y="3907860"/>
            <a:ext cx="1025642" cy="1025356"/>
          </a:xfrm>
          <a:custGeom>
            <a:avLst/>
            <a:gdLst>
              <a:gd name="connsiteX0" fmla="*/ 185 w 1025642"/>
              <a:gd name="connsiteY0" fmla="*/ 58 h 1025356"/>
              <a:gd name="connsiteX1" fmla="*/ 1025827 w 1025642"/>
              <a:gd name="connsiteY1" fmla="*/ 58 h 1025356"/>
              <a:gd name="connsiteX2" fmla="*/ 1025827 w 1025642"/>
              <a:gd name="connsiteY2" fmla="*/ 1025415 h 1025356"/>
              <a:gd name="connsiteX3" fmla="*/ 185 w 1025642"/>
              <a:gd name="connsiteY3" fmla="*/ 1025415 h 102535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25642" h="1025356">
                <a:moveTo>
                  <a:pt x="185" y="58"/>
                </a:moveTo>
                <a:lnTo>
                  <a:pt x="1025827" y="58"/>
                </a:lnTo>
                <a:lnTo>
                  <a:pt x="1025827" y="1025415"/>
                </a:lnTo>
                <a:lnTo>
                  <a:pt x="185" y="1025415"/>
                </a:lnTo>
                <a:close/>
              </a:path>
            </a:pathLst>
          </a:custGeom>
        </p:spPr>
      </p:pic>
      <p:pic>
        <p:nvPicPr>
          <p:cNvPr id="21" name="图形 5">
            <a:extLst>
              <a:ext uri="{FF2B5EF4-FFF2-40B4-BE49-F238E27FC236}">
                <a16:creationId xmlns:a16="http://schemas.microsoft.com/office/drawing/2014/main" id="{D371B848-3C68-4C40-B0B6-9B831D35251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234792" y="2833716"/>
            <a:ext cx="1025642" cy="1025356"/>
          </a:xfrm>
          <a:custGeom>
            <a:avLst/>
            <a:gdLst>
              <a:gd name="connsiteX0" fmla="*/ 185 w 1025642"/>
              <a:gd name="connsiteY0" fmla="*/ -54 h 1025356"/>
              <a:gd name="connsiteX1" fmla="*/ 1025827 w 1025642"/>
              <a:gd name="connsiteY1" fmla="*/ -54 h 1025356"/>
              <a:gd name="connsiteX2" fmla="*/ 1025827 w 1025642"/>
              <a:gd name="connsiteY2" fmla="*/ 1025302 h 1025356"/>
              <a:gd name="connsiteX3" fmla="*/ 185 w 1025642"/>
              <a:gd name="connsiteY3" fmla="*/ 1025302 h 102535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25642" h="1025356">
                <a:moveTo>
                  <a:pt x="185" y="-54"/>
                </a:moveTo>
                <a:lnTo>
                  <a:pt x="1025827" y="-54"/>
                </a:lnTo>
                <a:lnTo>
                  <a:pt x="1025827" y="1025302"/>
                </a:lnTo>
                <a:lnTo>
                  <a:pt x="185" y="1025302"/>
                </a:lnTo>
                <a:close/>
              </a:path>
            </a:pathLst>
          </a:custGeom>
        </p:spPr>
      </p:pic>
      <p:pic>
        <p:nvPicPr>
          <p:cNvPr id="22" name="图形 5">
            <a:extLst>
              <a:ext uri="{FF2B5EF4-FFF2-40B4-BE49-F238E27FC236}">
                <a16:creationId xmlns:a16="http://schemas.microsoft.com/office/drawing/2014/main" id="{D371B848-3C68-4C40-B0B6-9B831D35251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42427" y="2833716"/>
            <a:ext cx="1025642" cy="1025356"/>
          </a:xfrm>
          <a:custGeom>
            <a:avLst/>
            <a:gdLst>
              <a:gd name="connsiteX0" fmla="*/ 70 w 1025642"/>
              <a:gd name="connsiteY0" fmla="*/ -54 h 1025356"/>
              <a:gd name="connsiteX1" fmla="*/ 1025712 w 1025642"/>
              <a:gd name="connsiteY1" fmla="*/ -54 h 1025356"/>
              <a:gd name="connsiteX2" fmla="*/ 1025712 w 1025642"/>
              <a:gd name="connsiteY2" fmla="*/ 1025302 h 1025356"/>
              <a:gd name="connsiteX3" fmla="*/ 70 w 1025642"/>
              <a:gd name="connsiteY3" fmla="*/ 1025302 h 102535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25642" h="1025356">
                <a:moveTo>
                  <a:pt x="70" y="-54"/>
                </a:moveTo>
                <a:lnTo>
                  <a:pt x="1025712" y="-54"/>
                </a:lnTo>
                <a:lnTo>
                  <a:pt x="1025712" y="1025302"/>
                </a:lnTo>
                <a:lnTo>
                  <a:pt x="70" y="1025302"/>
                </a:lnTo>
                <a:close/>
              </a:path>
            </a:pathLst>
          </a:custGeom>
        </p:spPr>
      </p:pic>
      <p:pic>
        <p:nvPicPr>
          <p:cNvPr id="23" name="图形 5">
            <a:extLst>
              <a:ext uri="{FF2B5EF4-FFF2-40B4-BE49-F238E27FC236}">
                <a16:creationId xmlns:a16="http://schemas.microsoft.com/office/drawing/2014/main" id="{D371B848-3C68-4C40-B0B6-9B831D35251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142427" y="1753658"/>
            <a:ext cx="1025642" cy="1025356"/>
          </a:xfrm>
          <a:custGeom>
            <a:avLst/>
            <a:gdLst>
              <a:gd name="connsiteX0" fmla="*/ 70 w 1025642"/>
              <a:gd name="connsiteY0" fmla="*/ -168 h 1025356"/>
              <a:gd name="connsiteX1" fmla="*/ 1025712 w 1025642"/>
              <a:gd name="connsiteY1" fmla="*/ -168 h 1025356"/>
              <a:gd name="connsiteX2" fmla="*/ 1025712 w 1025642"/>
              <a:gd name="connsiteY2" fmla="*/ 1025189 h 1025356"/>
              <a:gd name="connsiteX3" fmla="*/ 70 w 1025642"/>
              <a:gd name="connsiteY3" fmla="*/ 1025189 h 102535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25642" h="1025356">
                <a:moveTo>
                  <a:pt x="70" y="-168"/>
                </a:moveTo>
                <a:lnTo>
                  <a:pt x="1025712" y="-168"/>
                </a:lnTo>
                <a:lnTo>
                  <a:pt x="1025712" y="1025189"/>
                </a:lnTo>
                <a:lnTo>
                  <a:pt x="70" y="1025189"/>
                </a:lnTo>
                <a:close/>
              </a:path>
            </a:pathLst>
          </a:custGeom>
        </p:spPr>
      </p:pic>
      <p:pic>
        <p:nvPicPr>
          <p:cNvPr id="24" name="图形 5">
            <a:extLst>
              <a:ext uri="{FF2B5EF4-FFF2-40B4-BE49-F238E27FC236}">
                <a16:creationId xmlns:a16="http://schemas.microsoft.com/office/drawing/2014/main" id="{D371B848-3C68-4C40-B0B6-9B831D35251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142427" y="3907860"/>
            <a:ext cx="1025642" cy="1025356"/>
          </a:xfrm>
          <a:custGeom>
            <a:avLst/>
            <a:gdLst>
              <a:gd name="connsiteX0" fmla="*/ 70 w 1025642"/>
              <a:gd name="connsiteY0" fmla="*/ 58 h 1025356"/>
              <a:gd name="connsiteX1" fmla="*/ 1025712 w 1025642"/>
              <a:gd name="connsiteY1" fmla="*/ 58 h 1025356"/>
              <a:gd name="connsiteX2" fmla="*/ 1025712 w 1025642"/>
              <a:gd name="connsiteY2" fmla="*/ 1025415 h 1025356"/>
              <a:gd name="connsiteX3" fmla="*/ 70 w 1025642"/>
              <a:gd name="connsiteY3" fmla="*/ 1025415 h 102535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25642" h="1025356">
                <a:moveTo>
                  <a:pt x="70" y="58"/>
                </a:moveTo>
                <a:lnTo>
                  <a:pt x="1025712" y="58"/>
                </a:lnTo>
                <a:lnTo>
                  <a:pt x="1025712" y="1025415"/>
                </a:lnTo>
                <a:lnTo>
                  <a:pt x="70" y="1025415"/>
                </a:lnTo>
                <a:close/>
              </a:path>
            </a:pathLst>
          </a:custGeom>
        </p:spPr>
      </p:pic>
      <p:pic>
        <p:nvPicPr>
          <p:cNvPr id="25" name="图形 5">
            <a:extLst>
              <a:ext uri="{FF2B5EF4-FFF2-40B4-BE49-F238E27FC236}">
                <a16:creationId xmlns:a16="http://schemas.microsoft.com/office/drawing/2014/main" id="{D371B848-3C68-4C40-B0B6-9B831D35251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050557" y="3907860"/>
            <a:ext cx="1025642" cy="1025356"/>
          </a:xfrm>
          <a:custGeom>
            <a:avLst/>
            <a:gdLst>
              <a:gd name="connsiteX0" fmla="*/ -45 w 1025642"/>
              <a:gd name="connsiteY0" fmla="*/ 58 h 1025356"/>
              <a:gd name="connsiteX1" fmla="*/ 1025598 w 1025642"/>
              <a:gd name="connsiteY1" fmla="*/ 58 h 1025356"/>
              <a:gd name="connsiteX2" fmla="*/ 1025598 w 1025642"/>
              <a:gd name="connsiteY2" fmla="*/ 1025415 h 1025356"/>
              <a:gd name="connsiteX3" fmla="*/ -45 w 1025642"/>
              <a:gd name="connsiteY3" fmla="*/ 1025415 h 102535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25642" h="1025356">
                <a:moveTo>
                  <a:pt x="-45" y="58"/>
                </a:moveTo>
                <a:lnTo>
                  <a:pt x="1025598" y="58"/>
                </a:lnTo>
                <a:lnTo>
                  <a:pt x="1025598" y="1025415"/>
                </a:lnTo>
                <a:lnTo>
                  <a:pt x="-45" y="1025415"/>
                </a:lnTo>
                <a:close/>
              </a:path>
            </a:pathLst>
          </a:custGeom>
        </p:spPr>
      </p:pic>
      <p:pic>
        <p:nvPicPr>
          <p:cNvPr id="26" name="图形 5">
            <a:extLst>
              <a:ext uri="{FF2B5EF4-FFF2-40B4-BE49-F238E27FC236}">
                <a16:creationId xmlns:a16="http://schemas.microsoft.com/office/drawing/2014/main" id="{D371B848-3C68-4C40-B0B6-9B831D352519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050557" y="2833716"/>
            <a:ext cx="1025642" cy="1025356"/>
          </a:xfrm>
          <a:custGeom>
            <a:avLst/>
            <a:gdLst>
              <a:gd name="connsiteX0" fmla="*/ -45 w 1025642"/>
              <a:gd name="connsiteY0" fmla="*/ -54 h 1025356"/>
              <a:gd name="connsiteX1" fmla="*/ 1025598 w 1025642"/>
              <a:gd name="connsiteY1" fmla="*/ -54 h 1025356"/>
              <a:gd name="connsiteX2" fmla="*/ 1025598 w 1025642"/>
              <a:gd name="connsiteY2" fmla="*/ 1025302 h 1025356"/>
              <a:gd name="connsiteX3" fmla="*/ -45 w 1025642"/>
              <a:gd name="connsiteY3" fmla="*/ 1025302 h 102535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25642" h="1025356">
                <a:moveTo>
                  <a:pt x="-45" y="-54"/>
                </a:moveTo>
                <a:lnTo>
                  <a:pt x="1025598" y="-54"/>
                </a:lnTo>
                <a:lnTo>
                  <a:pt x="1025598" y="1025302"/>
                </a:lnTo>
                <a:lnTo>
                  <a:pt x="-45" y="1025302"/>
                </a:lnTo>
                <a:close/>
              </a:path>
            </a:pathLst>
          </a:custGeom>
        </p:spPr>
      </p:pic>
      <p:pic>
        <p:nvPicPr>
          <p:cNvPr id="27" name="图形 5">
            <a:extLst>
              <a:ext uri="{FF2B5EF4-FFF2-40B4-BE49-F238E27FC236}">
                <a16:creationId xmlns:a16="http://schemas.microsoft.com/office/drawing/2014/main" id="{D371B848-3C68-4C40-B0B6-9B831D352519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050557" y="1753658"/>
            <a:ext cx="1025642" cy="1025356"/>
          </a:xfrm>
          <a:custGeom>
            <a:avLst/>
            <a:gdLst>
              <a:gd name="connsiteX0" fmla="*/ -45 w 1025642"/>
              <a:gd name="connsiteY0" fmla="*/ -168 h 1025356"/>
              <a:gd name="connsiteX1" fmla="*/ 1025598 w 1025642"/>
              <a:gd name="connsiteY1" fmla="*/ -168 h 1025356"/>
              <a:gd name="connsiteX2" fmla="*/ 1025598 w 1025642"/>
              <a:gd name="connsiteY2" fmla="*/ 1025189 h 1025356"/>
              <a:gd name="connsiteX3" fmla="*/ -45 w 1025642"/>
              <a:gd name="connsiteY3" fmla="*/ 1025189 h 102535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25642" h="1025356">
                <a:moveTo>
                  <a:pt x="-45" y="-168"/>
                </a:moveTo>
                <a:lnTo>
                  <a:pt x="1025598" y="-168"/>
                </a:lnTo>
                <a:lnTo>
                  <a:pt x="1025598" y="1025189"/>
                </a:lnTo>
                <a:lnTo>
                  <a:pt x="-45" y="1025189"/>
                </a:lnTo>
                <a:close/>
              </a:path>
            </a:pathLst>
          </a:custGeom>
        </p:spPr>
      </p:pic>
      <p:pic>
        <p:nvPicPr>
          <p:cNvPr id="28" name="图形 5">
            <a:extLst>
              <a:ext uri="{FF2B5EF4-FFF2-40B4-BE49-F238E27FC236}">
                <a16:creationId xmlns:a16="http://schemas.microsoft.com/office/drawing/2014/main" id="{D371B848-3C68-4C40-B0B6-9B831D352519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947048" y="2833716"/>
            <a:ext cx="1025642" cy="1025356"/>
          </a:xfrm>
          <a:custGeom>
            <a:avLst/>
            <a:gdLst>
              <a:gd name="connsiteX0" fmla="*/ -161 w 1025642"/>
              <a:gd name="connsiteY0" fmla="*/ -54 h 1025356"/>
              <a:gd name="connsiteX1" fmla="*/ 1025482 w 1025642"/>
              <a:gd name="connsiteY1" fmla="*/ -54 h 1025356"/>
              <a:gd name="connsiteX2" fmla="*/ 1025482 w 1025642"/>
              <a:gd name="connsiteY2" fmla="*/ 1025302 h 1025356"/>
              <a:gd name="connsiteX3" fmla="*/ -161 w 1025642"/>
              <a:gd name="connsiteY3" fmla="*/ 1025302 h 102535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25642" h="1025356">
                <a:moveTo>
                  <a:pt x="-161" y="-54"/>
                </a:moveTo>
                <a:lnTo>
                  <a:pt x="1025482" y="-54"/>
                </a:lnTo>
                <a:lnTo>
                  <a:pt x="1025482" y="1025302"/>
                </a:lnTo>
                <a:lnTo>
                  <a:pt x="-161" y="1025302"/>
                </a:lnTo>
                <a:close/>
              </a:path>
            </a:pathLst>
          </a:custGeom>
        </p:spPr>
      </p:pic>
      <p:pic>
        <p:nvPicPr>
          <p:cNvPr id="65" name="图形 5">
            <a:extLst>
              <a:ext uri="{FF2B5EF4-FFF2-40B4-BE49-F238E27FC236}">
                <a16:creationId xmlns:a16="http://schemas.microsoft.com/office/drawing/2014/main" id="{D371B848-3C68-4C40-B0B6-9B831D352519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947048" y="1753658"/>
            <a:ext cx="1025642" cy="1025356"/>
          </a:xfrm>
          <a:custGeom>
            <a:avLst/>
            <a:gdLst>
              <a:gd name="connsiteX0" fmla="*/ -161 w 1025642"/>
              <a:gd name="connsiteY0" fmla="*/ -168 h 1025356"/>
              <a:gd name="connsiteX1" fmla="*/ 1025482 w 1025642"/>
              <a:gd name="connsiteY1" fmla="*/ -168 h 1025356"/>
              <a:gd name="connsiteX2" fmla="*/ 1025482 w 1025642"/>
              <a:gd name="connsiteY2" fmla="*/ 1025189 h 1025356"/>
              <a:gd name="connsiteX3" fmla="*/ -161 w 1025642"/>
              <a:gd name="connsiteY3" fmla="*/ 1025189 h 102535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25642" h="1025356">
                <a:moveTo>
                  <a:pt x="-161" y="-168"/>
                </a:moveTo>
                <a:lnTo>
                  <a:pt x="1025482" y="-168"/>
                </a:lnTo>
                <a:lnTo>
                  <a:pt x="1025482" y="1025189"/>
                </a:lnTo>
                <a:lnTo>
                  <a:pt x="-161" y="1025189"/>
                </a:lnTo>
                <a:close/>
              </a:path>
            </a:pathLst>
          </a:custGeom>
        </p:spPr>
      </p:pic>
      <p:pic>
        <p:nvPicPr>
          <p:cNvPr id="66" name="图形 5">
            <a:extLst>
              <a:ext uri="{FF2B5EF4-FFF2-40B4-BE49-F238E27FC236}">
                <a16:creationId xmlns:a16="http://schemas.microsoft.com/office/drawing/2014/main" id="{D371B848-3C68-4C40-B0B6-9B831D352519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947048" y="3907860"/>
            <a:ext cx="1025642" cy="1025356"/>
          </a:xfrm>
          <a:custGeom>
            <a:avLst/>
            <a:gdLst>
              <a:gd name="connsiteX0" fmla="*/ -161 w 1025642"/>
              <a:gd name="connsiteY0" fmla="*/ 58 h 1025356"/>
              <a:gd name="connsiteX1" fmla="*/ 1025482 w 1025642"/>
              <a:gd name="connsiteY1" fmla="*/ 58 h 1025356"/>
              <a:gd name="connsiteX2" fmla="*/ 1025482 w 1025642"/>
              <a:gd name="connsiteY2" fmla="*/ 1025415 h 1025356"/>
              <a:gd name="connsiteX3" fmla="*/ -161 w 1025642"/>
              <a:gd name="connsiteY3" fmla="*/ 1025415 h 102535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25642" h="1025356">
                <a:moveTo>
                  <a:pt x="-161" y="58"/>
                </a:moveTo>
                <a:lnTo>
                  <a:pt x="1025482" y="58"/>
                </a:lnTo>
                <a:lnTo>
                  <a:pt x="1025482" y="1025415"/>
                </a:lnTo>
                <a:lnTo>
                  <a:pt x="-161" y="1025415"/>
                </a:lnTo>
                <a:close/>
              </a:path>
            </a:pathLst>
          </a:custGeom>
        </p:spPr>
      </p:pic>
      <p:sp>
        <p:nvSpPr>
          <p:cNvPr id="75" name="文本框 74">
            <a:extLst>
              <a:ext uri="{FF2B5EF4-FFF2-40B4-BE49-F238E27FC236}">
                <a16:creationId xmlns:a16="http://schemas.microsoft.com/office/drawing/2014/main" id="{4C5301BA-359A-479D-86F9-592D8D8071A3}"/>
              </a:ext>
            </a:extLst>
          </p:cNvPr>
          <p:cNvSpPr txBox="1"/>
          <p:nvPr/>
        </p:nvSpPr>
        <p:spPr>
          <a:xfrm>
            <a:off x="1959635" y="3161728"/>
            <a:ext cx="17287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estrin2 shRNA</a:t>
            </a:r>
            <a:endParaRPr lang="zh-CN" altLang="en-US" dirty="0"/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1F72D45B-7B7F-46FC-B3D5-5FA6B4938BCD}"/>
              </a:ext>
            </a:extLst>
          </p:cNvPr>
          <p:cNvSpPr txBox="1"/>
          <p:nvPr/>
        </p:nvSpPr>
        <p:spPr>
          <a:xfrm>
            <a:off x="2179309" y="103459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is</a:t>
            </a:r>
            <a:endParaRPr lang="zh-CN" altLang="en-US" dirty="0"/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2384C5FB-72D6-4326-8363-2007A25F7F84}"/>
              </a:ext>
            </a:extLst>
          </p:cNvPr>
          <p:cNvSpPr txBox="1"/>
          <p:nvPr/>
        </p:nvSpPr>
        <p:spPr>
          <a:xfrm>
            <a:off x="2179309" y="1384326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Rap</a:t>
            </a:r>
            <a:endParaRPr lang="zh-CN" altLang="en-US" dirty="0"/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EB9BC65A-4261-4A9A-9FAA-42D23DC9C627}"/>
              </a:ext>
            </a:extLst>
          </p:cNvPr>
          <p:cNvSpPr txBox="1"/>
          <p:nvPr/>
        </p:nvSpPr>
        <p:spPr>
          <a:xfrm>
            <a:off x="6529117" y="1001130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-</a:t>
            </a:r>
            <a:endParaRPr lang="zh-CN" altLang="en-US" dirty="0"/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074E42F6-9E9E-45D3-B3CF-CD2370537CFC}"/>
              </a:ext>
            </a:extLst>
          </p:cNvPr>
          <p:cNvSpPr txBox="1"/>
          <p:nvPr/>
        </p:nvSpPr>
        <p:spPr>
          <a:xfrm>
            <a:off x="5486835" y="1394845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-</a:t>
            </a:r>
            <a:endParaRPr lang="zh-CN" altLang="en-US" dirty="0"/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BE33B8A3-DFAF-4962-87E9-B12CCF38C8E0}"/>
              </a:ext>
            </a:extLst>
          </p:cNvPr>
          <p:cNvSpPr txBox="1"/>
          <p:nvPr/>
        </p:nvSpPr>
        <p:spPr>
          <a:xfrm>
            <a:off x="7587978" y="1025514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+</a:t>
            </a:r>
            <a:endParaRPr lang="zh-CN" altLang="en-US" dirty="0"/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C43B99E9-C2B4-44B8-B4E6-CD9A13BFD9DD}"/>
              </a:ext>
            </a:extLst>
          </p:cNvPr>
          <p:cNvSpPr txBox="1"/>
          <p:nvPr/>
        </p:nvSpPr>
        <p:spPr>
          <a:xfrm>
            <a:off x="6528929" y="1415926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+</a:t>
            </a:r>
            <a:endParaRPr lang="zh-CN" altLang="en-US" dirty="0"/>
          </a:p>
        </p:txBody>
      </p:sp>
      <p:sp>
        <p:nvSpPr>
          <p:cNvPr id="83" name="文本框 82">
            <a:extLst>
              <a:ext uri="{FF2B5EF4-FFF2-40B4-BE49-F238E27FC236}">
                <a16:creationId xmlns:a16="http://schemas.microsoft.com/office/drawing/2014/main" id="{92991839-2DEC-46BC-9D35-4508F7CCA1A5}"/>
              </a:ext>
            </a:extLst>
          </p:cNvPr>
          <p:cNvSpPr txBox="1"/>
          <p:nvPr/>
        </p:nvSpPr>
        <p:spPr>
          <a:xfrm>
            <a:off x="7625361" y="1442809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+</a:t>
            </a:r>
            <a:endParaRPr lang="zh-CN" altLang="en-US" dirty="0"/>
          </a:p>
        </p:txBody>
      </p:sp>
      <p:sp>
        <p:nvSpPr>
          <p:cNvPr id="84" name="文本框 83">
            <a:extLst>
              <a:ext uri="{FF2B5EF4-FFF2-40B4-BE49-F238E27FC236}">
                <a16:creationId xmlns:a16="http://schemas.microsoft.com/office/drawing/2014/main" id="{D81FCA7E-375C-42A9-9A87-EB4EB1AC6455}"/>
              </a:ext>
            </a:extLst>
          </p:cNvPr>
          <p:cNvSpPr txBox="1"/>
          <p:nvPr/>
        </p:nvSpPr>
        <p:spPr>
          <a:xfrm>
            <a:off x="5453320" y="1033544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+</a:t>
            </a:r>
            <a:endParaRPr lang="zh-CN" altLang="en-US" dirty="0"/>
          </a:p>
        </p:txBody>
      </p:sp>
      <p:sp>
        <p:nvSpPr>
          <p:cNvPr id="85" name="文本框 84">
            <a:extLst>
              <a:ext uri="{FF2B5EF4-FFF2-40B4-BE49-F238E27FC236}">
                <a16:creationId xmlns:a16="http://schemas.microsoft.com/office/drawing/2014/main" id="{0D13E374-A869-49BC-9981-736BD79B109C}"/>
              </a:ext>
            </a:extLst>
          </p:cNvPr>
          <p:cNvSpPr txBox="1"/>
          <p:nvPr/>
        </p:nvSpPr>
        <p:spPr>
          <a:xfrm>
            <a:off x="4275409" y="1390525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-</a:t>
            </a:r>
            <a:endParaRPr lang="zh-CN" altLang="en-US" dirty="0"/>
          </a:p>
        </p:txBody>
      </p:sp>
      <p:sp>
        <p:nvSpPr>
          <p:cNvPr id="86" name="文本框 85">
            <a:extLst>
              <a:ext uri="{FF2B5EF4-FFF2-40B4-BE49-F238E27FC236}">
                <a16:creationId xmlns:a16="http://schemas.microsoft.com/office/drawing/2014/main" id="{5593EBD9-8736-4639-BFE2-C56DC6FC0436}"/>
              </a:ext>
            </a:extLst>
          </p:cNvPr>
          <p:cNvSpPr txBox="1"/>
          <p:nvPr/>
        </p:nvSpPr>
        <p:spPr>
          <a:xfrm>
            <a:off x="4275409" y="998256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-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1835740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5F9126BC-F554-456B-9105-D8B198DB785D}"/>
              </a:ext>
            </a:extLst>
          </p:cNvPr>
          <p:cNvSpPr txBox="1"/>
          <p:nvPr/>
        </p:nvSpPr>
        <p:spPr>
          <a:xfrm>
            <a:off x="70386" y="5667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 3E</a:t>
            </a:r>
            <a:endParaRPr lang="zh-CN" altLang="en-US" dirty="0"/>
          </a:p>
        </p:txBody>
      </p:sp>
      <p:pic>
        <p:nvPicPr>
          <p:cNvPr id="3" name="图形 5">
            <a:extLst>
              <a:ext uri="{FF2B5EF4-FFF2-40B4-BE49-F238E27FC236}">
                <a16:creationId xmlns:a16="http://schemas.microsoft.com/office/drawing/2014/main" id="{489E6EDF-757B-4511-83B8-3B07B1ECFB2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19465" y="3135263"/>
            <a:ext cx="1025642" cy="1025356"/>
          </a:xfrm>
          <a:custGeom>
            <a:avLst/>
            <a:gdLst>
              <a:gd name="connsiteX0" fmla="*/ 185 w 1025642"/>
              <a:gd name="connsiteY0" fmla="*/ 314 h 1025356"/>
              <a:gd name="connsiteX1" fmla="*/ 1025827 w 1025642"/>
              <a:gd name="connsiteY1" fmla="*/ 314 h 1025356"/>
              <a:gd name="connsiteX2" fmla="*/ 1025827 w 1025642"/>
              <a:gd name="connsiteY2" fmla="*/ 1025671 h 1025356"/>
              <a:gd name="connsiteX3" fmla="*/ 185 w 1025642"/>
              <a:gd name="connsiteY3" fmla="*/ 1025671 h 102535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25642" h="1025356">
                <a:moveTo>
                  <a:pt x="185" y="314"/>
                </a:moveTo>
                <a:lnTo>
                  <a:pt x="1025827" y="314"/>
                </a:lnTo>
                <a:lnTo>
                  <a:pt x="1025827" y="1025671"/>
                </a:lnTo>
                <a:lnTo>
                  <a:pt x="185" y="1025671"/>
                </a:lnTo>
                <a:close/>
              </a:path>
            </a:pathLst>
          </a:custGeom>
        </p:spPr>
      </p:pic>
      <p:pic>
        <p:nvPicPr>
          <p:cNvPr id="4" name="图形 5">
            <a:extLst>
              <a:ext uri="{FF2B5EF4-FFF2-40B4-BE49-F238E27FC236}">
                <a16:creationId xmlns:a16="http://schemas.microsoft.com/office/drawing/2014/main" id="{97CC0D1E-15C8-4411-8EDA-8CDAA8F82C0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19465" y="2056509"/>
            <a:ext cx="1025642" cy="1025356"/>
          </a:xfrm>
          <a:custGeom>
            <a:avLst/>
            <a:gdLst>
              <a:gd name="connsiteX0" fmla="*/ 185 w 1025642"/>
              <a:gd name="connsiteY0" fmla="*/ 201 h 1025356"/>
              <a:gd name="connsiteX1" fmla="*/ 1025827 w 1025642"/>
              <a:gd name="connsiteY1" fmla="*/ 201 h 1025356"/>
              <a:gd name="connsiteX2" fmla="*/ 1025827 w 1025642"/>
              <a:gd name="connsiteY2" fmla="*/ 1025558 h 1025356"/>
              <a:gd name="connsiteX3" fmla="*/ 185 w 1025642"/>
              <a:gd name="connsiteY3" fmla="*/ 1025558 h 102535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25642" h="1025356">
                <a:moveTo>
                  <a:pt x="185" y="201"/>
                </a:moveTo>
                <a:lnTo>
                  <a:pt x="1025827" y="201"/>
                </a:lnTo>
                <a:lnTo>
                  <a:pt x="1025827" y="1025558"/>
                </a:lnTo>
                <a:lnTo>
                  <a:pt x="185" y="1025558"/>
                </a:lnTo>
                <a:close/>
              </a:path>
            </a:pathLst>
          </a:custGeom>
        </p:spPr>
      </p:pic>
      <p:pic>
        <p:nvPicPr>
          <p:cNvPr id="5" name="图形 5">
            <a:extLst>
              <a:ext uri="{FF2B5EF4-FFF2-40B4-BE49-F238E27FC236}">
                <a16:creationId xmlns:a16="http://schemas.microsoft.com/office/drawing/2014/main" id="{A30B2521-5739-407E-8CE1-E73C4A15363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319465" y="4211550"/>
            <a:ext cx="1025642" cy="1025356"/>
          </a:xfrm>
          <a:custGeom>
            <a:avLst/>
            <a:gdLst>
              <a:gd name="connsiteX0" fmla="*/ 185 w 1025642"/>
              <a:gd name="connsiteY0" fmla="*/ 427 h 1025356"/>
              <a:gd name="connsiteX1" fmla="*/ 1025827 w 1025642"/>
              <a:gd name="connsiteY1" fmla="*/ 427 h 1025356"/>
              <a:gd name="connsiteX2" fmla="*/ 1025827 w 1025642"/>
              <a:gd name="connsiteY2" fmla="*/ 1025784 h 1025356"/>
              <a:gd name="connsiteX3" fmla="*/ 185 w 1025642"/>
              <a:gd name="connsiteY3" fmla="*/ 1025784 h 102535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25642" h="1025356">
                <a:moveTo>
                  <a:pt x="185" y="427"/>
                </a:moveTo>
                <a:lnTo>
                  <a:pt x="1025827" y="427"/>
                </a:lnTo>
                <a:lnTo>
                  <a:pt x="1025827" y="1025784"/>
                </a:lnTo>
                <a:lnTo>
                  <a:pt x="185" y="1025784"/>
                </a:lnTo>
                <a:close/>
              </a:path>
            </a:pathLst>
          </a:custGeom>
        </p:spPr>
      </p:pic>
      <p:pic>
        <p:nvPicPr>
          <p:cNvPr id="6" name="图形 5">
            <a:extLst>
              <a:ext uri="{FF2B5EF4-FFF2-40B4-BE49-F238E27FC236}">
                <a16:creationId xmlns:a16="http://schemas.microsoft.com/office/drawing/2014/main" id="{A15F4603-95C4-48BF-A3C1-D068FB4B313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227100" y="3135263"/>
            <a:ext cx="1025642" cy="1025356"/>
          </a:xfrm>
          <a:custGeom>
            <a:avLst/>
            <a:gdLst>
              <a:gd name="connsiteX0" fmla="*/ 70 w 1025642"/>
              <a:gd name="connsiteY0" fmla="*/ 314 h 1025356"/>
              <a:gd name="connsiteX1" fmla="*/ 1025712 w 1025642"/>
              <a:gd name="connsiteY1" fmla="*/ 314 h 1025356"/>
              <a:gd name="connsiteX2" fmla="*/ 1025712 w 1025642"/>
              <a:gd name="connsiteY2" fmla="*/ 1025671 h 1025356"/>
              <a:gd name="connsiteX3" fmla="*/ 70 w 1025642"/>
              <a:gd name="connsiteY3" fmla="*/ 1025671 h 102535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25642" h="1025356">
                <a:moveTo>
                  <a:pt x="70" y="314"/>
                </a:moveTo>
                <a:lnTo>
                  <a:pt x="1025712" y="314"/>
                </a:lnTo>
                <a:lnTo>
                  <a:pt x="1025712" y="1025671"/>
                </a:lnTo>
                <a:lnTo>
                  <a:pt x="70" y="1025671"/>
                </a:lnTo>
                <a:close/>
              </a:path>
            </a:pathLst>
          </a:custGeom>
        </p:spPr>
      </p:pic>
      <p:pic>
        <p:nvPicPr>
          <p:cNvPr id="7" name="图形 5">
            <a:extLst>
              <a:ext uri="{FF2B5EF4-FFF2-40B4-BE49-F238E27FC236}">
                <a16:creationId xmlns:a16="http://schemas.microsoft.com/office/drawing/2014/main" id="{15C030E2-5DA2-4828-AD57-22BFA5C8C3B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227100" y="2056509"/>
            <a:ext cx="1025642" cy="1025356"/>
          </a:xfrm>
          <a:custGeom>
            <a:avLst/>
            <a:gdLst>
              <a:gd name="connsiteX0" fmla="*/ 70 w 1025642"/>
              <a:gd name="connsiteY0" fmla="*/ 201 h 1025356"/>
              <a:gd name="connsiteX1" fmla="*/ 1025712 w 1025642"/>
              <a:gd name="connsiteY1" fmla="*/ 201 h 1025356"/>
              <a:gd name="connsiteX2" fmla="*/ 1025712 w 1025642"/>
              <a:gd name="connsiteY2" fmla="*/ 1025558 h 1025356"/>
              <a:gd name="connsiteX3" fmla="*/ 70 w 1025642"/>
              <a:gd name="connsiteY3" fmla="*/ 1025558 h 102535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25642" h="1025356">
                <a:moveTo>
                  <a:pt x="70" y="201"/>
                </a:moveTo>
                <a:lnTo>
                  <a:pt x="1025712" y="201"/>
                </a:lnTo>
                <a:lnTo>
                  <a:pt x="1025712" y="1025558"/>
                </a:lnTo>
                <a:lnTo>
                  <a:pt x="70" y="1025558"/>
                </a:lnTo>
                <a:close/>
              </a:path>
            </a:pathLst>
          </a:custGeom>
        </p:spPr>
      </p:pic>
      <p:pic>
        <p:nvPicPr>
          <p:cNvPr id="8" name="图形 5">
            <a:extLst>
              <a:ext uri="{FF2B5EF4-FFF2-40B4-BE49-F238E27FC236}">
                <a16:creationId xmlns:a16="http://schemas.microsoft.com/office/drawing/2014/main" id="{F6DEA449-29CF-40DF-86A0-A18ED4E183F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227100" y="4211550"/>
            <a:ext cx="1025642" cy="1025356"/>
          </a:xfrm>
          <a:custGeom>
            <a:avLst/>
            <a:gdLst>
              <a:gd name="connsiteX0" fmla="*/ 70 w 1025642"/>
              <a:gd name="connsiteY0" fmla="*/ 427 h 1025356"/>
              <a:gd name="connsiteX1" fmla="*/ 1025712 w 1025642"/>
              <a:gd name="connsiteY1" fmla="*/ 427 h 1025356"/>
              <a:gd name="connsiteX2" fmla="*/ 1025712 w 1025642"/>
              <a:gd name="connsiteY2" fmla="*/ 1025784 h 1025356"/>
              <a:gd name="connsiteX3" fmla="*/ 70 w 1025642"/>
              <a:gd name="connsiteY3" fmla="*/ 1025784 h 102535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25642" h="1025356">
                <a:moveTo>
                  <a:pt x="70" y="427"/>
                </a:moveTo>
                <a:lnTo>
                  <a:pt x="1025712" y="427"/>
                </a:lnTo>
                <a:lnTo>
                  <a:pt x="1025712" y="1025784"/>
                </a:lnTo>
                <a:lnTo>
                  <a:pt x="70" y="1025784"/>
                </a:lnTo>
                <a:close/>
              </a:path>
            </a:pathLst>
          </a:custGeom>
        </p:spPr>
      </p:pic>
      <p:pic>
        <p:nvPicPr>
          <p:cNvPr id="9" name="图形 5">
            <a:extLst>
              <a:ext uri="{FF2B5EF4-FFF2-40B4-BE49-F238E27FC236}">
                <a16:creationId xmlns:a16="http://schemas.microsoft.com/office/drawing/2014/main" id="{C8AFEF98-849B-4F72-98EC-D603D3C290C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031721" y="3135263"/>
            <a:ext cx="1025642" cy="1025356"/>
          </a:xfrm>
          <a:custGeom>
            <a:avLst/>
            <a:gdLst>
              <a:gd name="connsiteX0" fmla="*/ -161 w 1025642"/>
              <a:gd name="connsiteY0" fmla="*/ 314 h 1025356"/>
              <a:gd name="connsiteX1" fmla="*/ 1025482 w 1025642"/>
              <a:gd name="connsiteY1" fmla="*/ 314 h 1025356"/>
              <a:gd name="connsiteX2" fmla="*/ 1025482 w 1025642"/>
              <a:gd name="connsiteY2" fmla="*/ 1025671 h 1025356"/>
              <a:gd name="connsiteX3" fmla="*/ -161 w 1025642"/>
              <a:gd name="connsiteY3" fmla="*/ 1025671 h 102535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25642" h="1025356">
                <a:moveTo>
                  <a:pt x="-161" y="314"/>
                </a:moveTo>
                <a:lnTo>
                  <a:pt x="1025482" y="314"/>
                </a:lnTo>
                <a:lnTo>
                  <a:pt x="1025482" y="1025671"/>
                </a:lnTo>
                <a:lnTo>
                  <a:pt x="-161" y="1025671"/>
                </a:lnTo>
                <a:close/>
              </a:path>
            </a:pathLst>
          </a:custGeom>
        </p:spPr>
      </p:pic>
      <p:pic>
        <p:nvPicPr>
          <p:cNvPr id="10" name="图形 5">
            <a:extLst>
              <a:ext uri="{FF2B5EF4-FFF2-40B4-BE49-F238E27FC236}">
                <a16:creationId xmlns:a16="http://schemas.microsoft.com/office/drawing/2014/main" id="{01EEE983-E44D-4355-88CA-43EF0A81DB4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031721" y="4211550"/>
            <a:ext cx="1025642" cy="1025356"/>
          </a:xfrm>
          <a:custGeom>
            <a:avLst/>
            <a:gdLst>
              <a:gd name="connsiteX0" fmla="*/ -161 w 1025642"/>
              <a:gd name="connsiteY0" fmla="*/ 427 h 1025356"/>
              <a:gd name="connsiteX1" fmla="*/ 1025482 w 1025642"/>
              <a:gd name="connsiteY1" fmla="*/ 427 h 1025356"/>
              <a:gd name="connsiteX2" fmla="*/ 1025482 w 1025642"/>
              <a:gd name="connsiteY2" fmla="*/ 1025784 h 1025356"/>
              <a:gd name="connsiteX3" fmla="*/ -161 w 1025642"/>
              <a:gd name="connsiteY3" fmla="*/ 1025784 h 102535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25642" h="1025356">
                <a:moveTo>
                  <a:pt x="-161" y="427"/>
                </a:moveTo>
                <a:lnTo>
                  <a:pt x="1025482" y="427"/>
                </a:lnTo>
                <a:lnTo>
                  <a:pt x="1025482" y="1025784"/>
                </a:lnTo>
                <a:lnTo>
                  <a:pt x="-161" y="1025784"/>
                </a:lnTo>
                <a:close/>
              </a:path>
            </a:pathLst>
          </a:custGeom>
        </p:spPr>
      </p:pic>
      <p:pic>
        <p:nvPicPr>
          <p:cNvPr id="11" name="图形 5">
            <a:extLst>
              <a:ext uri="{FF2B5EF4-FFF2-40B4-BE49-F238E27FC236}">
                <a16:creationId xmlns:a16="http://schemas.microsoft.com/office/drawing/2014/main" id="{BFB76473-8E4C-4651-B8BE-35F677EBB49E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031721" y="2056509"/>
            <a:ext cx="1025642" cy="1025356"/>
          </a:xfrm>
          <a:custGeom>
            <a:avLst/>
            <a:gdLst>
              <a:gd name="connsiteX0" fmla="*/ -161 w 1025642"/>
              <a:gd name="connsiteY0" fmla="*/ 201 h 1025356"/>
              <a:gd name="connsiteX1" fmla="*/ 1025482 w 1025642"/>
              <a:gd name="connsiteY1" fmla="*/ 201 h 1025356"/>
              <a:gd name="connsiteX2" fmla="*/ 1025482 w 1025642"/>
              <a:gd name="connsiteY2" fmla="*/ 1025558 h 1025356"/>
              <a:gd name="connsiteX3" fmla="*/ -161 w 1025642"/>
              <a:gd name="connsiteY3" fmla="*/ 1025558 h 102535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25642" h="1025356">
                <a:moveTo>
                  <a:pt x="-161" y="201"/>
                </a:moveTo>
                <a:lnTo>
                  <a:pt x="1025482" y="201"/>
                </a:lnTo>
                <a:lnTo>
                  <a:pt x="1025482" y="1025558"/>
                </a:lnTo>
                <a:lnTo>
                  <a:pt x="-161" y="1025558"/>
                </a:lnTo>
                <a:close/>
              </a:path>
            </a:pathLst>
          </a:custGeom>
        </p:spPr>
      </p:pic>
      <p:pic>
        <p:nvPicPr>
          <p:cNvPr id="12" name="图形 5">
            <a:extLst>
              <a:ext uri="{FF2B5EF4-FFF2-40B4-BE49-F238E27FC236}">
                <a16:creationId xmlns:a16="http://schemas.microsoft.com/office/drawing/2014/main" id="{0FEB117B-B3C5-4BA3-A186-AED3570C63A6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135230" y="3135263"/>
            <a:ext cx="1025642" cy="1025356"/>
          </a:xfrm>
          <a:custGeom>
            <a:avLst/>
            <a:gdLst>
              <a:gd name="connsiteX0" fmla="*/ -45 w 1025642"/>
              <a:gd name="connsiteY0" fmla="*/ 314 h 1025356"/>
              <a:gd name="connsiteX1" fmla="*/ 1025598 w 1025642"/>
              <a:gd name="connsiteY1" fmla="*/ 314 h 1025356"/>
              <a:gd name="connsiteX2" fmla="*/ 1025598 w 1025642"/>
              <a:gd name="connsiteY2" fmla="*/ 1025671 h 1025356"/>
              <a:gd name="connsiteX3" fmla="*/ -45 w 1025642"/>
              <a:gd name="connsiteY3" fmla="*/ 1025671 h 102535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25642" h="1025356">
                <a:moveTo>
                  <a:pt x="-45" y="314"/>
                </a:moveTo>
                <a:lnTo>
                  <a:pt x="1025598" y="314"/>
                </a:lnTo>
                <a:lnTo>
                  <a:pt x="1025598" y="1025671"/>
                </a:lnTo>
                <a:lnTo>
                  <a:pt x="-45" y="1025671"/>
                </a:lnTo>
                <a:close/>
              </a:path>
            </a:pathLst>
          </a:custGeom>
        </p:spPr>
      </p:pic>
      <p:pic>
        <p:nvPicPr>
          <p:cNvPr id="13" name="图形 5">
            <a:extLst>
              <a:ext uri="{FF2B5EF4-FFF2-40B4-BE49-F238E27FC236}">
                <a16:creationId xmlns:a16="http://schemas.microsoft.com/office/drawing/2014/main" id="{B6267695-D74D-4ADC-907D-ADCB671F819B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135230" y="2056509"/>
            <a:ext cx="1025642" cy="1025356"/>
          </a:xfrm>
          <a:custGeom>
            <a:avLst/>
            <a:gdLst>
              <a:gd name="connsiteX0" fmla="*/ -45 w 1025642"/>
              <a:gd name="connsiteY0" fmla="*/ 201 h 1025356"/>
              <a:gd name="connsiteX1" fmla="*/ 1025598 w 1025642"/>
              <a:gd name="connsiteY1" fmla="*/ 201 h 1025356"/>
              <a:gd name="connsiteX2" fmla="*/ 1025598 w 1025642"/>
              <a:gd name="connsiteY2" fmla="*/ 1025558 h 1025356"/>
              <a:gd name="connsiteX3" fmla="*/ -45 w 1025642"/>
              <a:gd name="connsiteY3" fmla="*/ 1025558 h 102535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25642" h="1025356">
                <a:moveTo>
                  <a:pt x="-45" y="201"/>
                </a:moveTo>
                <a:lnTo>
                  <a:pt x="1025598" y="201"/>
                </a:lnTo>
                <a:lnTo>
                  <a:pt x="1025598" y="1025558"/>
                </a:lnTo>
                <a:lnTo>
                  <a:pt x="-45" y="1025558"/>
                </a:lnTo>
                <a:close/>
              </a:path>
            </a:pathLst>
          </a:custGeom>
        </p:spPr>
      </p:pic>
      <p:pic>
        <p:nvPicPr>
          <p:cNvPr id="14" name="图形 5">
            <a:extLst>
              <a:ext uri="{FF2B5EF4-FFF2-40B4-BE49-F238E27FC236}">
                <a16:creationId xmlns:a16="http://schemas.microsoft.com/office/drawing/2014/main" id="{06C7955E-E5BB-4FA2-B33F-C43979C7E5B0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135230" y="4211550"/>
            <a:ext cx="1025642" cy="1025356"/>
          </a:xfrm>
          <a:custGeom>
            <a:avLst/>
            <a:gdLst>
              <a:gd name="connsiteX0" fmla="*/ -45 w 1025642"/>
              <a:gd name="connsiteY0" fmla="*/ 427 h 1025356"/>
              <a:gd name="connsiteX1" fmla="*/ 1025598 w 1025642"/>
              <a:gd name="connsiteY1" fmla="*/ 427 h 1025356"/>
              <a:gd name="connsiteX2" fmla="*/ 1025598 w 1025642"/>
              <a:gd name="connsiteY2" fmla="*/ 1025784 h 1025356"/>
              <a:gd name="connsiteX3" fmla="*/ -45 w 1025642"/>
              <a:gd name="connsiteY3" fmla="*/ 1025784 h 102535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25642" h="1025356">
                <a:moveTo>
                  <a:pt x="-45" y="427"/>
                </a:moveTo>
                <a:lnTo>
                  <a:pt x="1025598" y="427"/>
                </a:lnTo>
                <a:lnTo>
                  <a:pt x="1025598" y="1025784"/>
                </a:lnTo>
                <a:lnTo>
                  <a:pt x="-45" y="1025784"/>
                </a:lnTo>
                <a:close/>
              </a:path>
            </a:pathLst>
          </a:cu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4C001137-5A7B-4DE8-90FF-3C6BEA52F616}"/>
              </a:ext>
            </a:extLst>
          </p:cNvPr>
          <p:cNvSpPr txBox="1"/>
          <p:nvPr/>
        </p:nvSpPr>
        <p:spPr>
          <a:xfrm>
            <a:off x="2015205" y="3526711"/>
            <a:ext cx="17287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trol shRNA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1586F49E-5B2F-4A07-9367-4B1E45C14C62}"/>
              </a:ext>
            </a:extLst>
          </p:cNvPr>
          <p:cNvSpPr txBox="1"/>
          <p:nvPr/>
        </p:nvSpPr>
        <p:spPr>
          <a:xfrm>
            <a:off x="2230110" y="1242564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is</a:t>
            </a:r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28643925-FAD5-4E16-8832-0F5E8EAD034E}"/>
              </a:ext>
            </a:extLst>
          </p:cNvPr>
          <p:cNvSpPr txBox="1"/>
          <p:nvPr/>
        </p:nvSpPr>
        <p:spPr>
          <a:xfrm>
            <a:off x="2230110" y="1592297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Rap</a:t>
            </a:r>
            <a:endParaRPr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98B52F93-4AD6-42D2-AFEC-2EBCB7925569}"/>
              </a:ext>
            </a:extLst>
          </p:cNvPr>
          <p:cNvSpPr txBox="1"/>
          <p:nvPr/>
        </p:nvSpPr>
        <p:spPr>
          <a:xfrm>
            <a:off x="6579918" y="1209101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-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687CB412-3AAF-46D6-B604-7E99FC6BE7C8}"/>
              </a:ext>
            </a:extLst>
          </p:cNvPr>
          <p:cNvSpPr txBox="1"/>
          <p:nvPr/>
        </p:nvSpPr>
        <p:spPr>
          <a:xfrm>
            <a:off x="5537636" y="1602816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-</a:t>
            </a:r>
            <a:endParaRPr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2D98B78D-A68A-46B3-8955-2C0ABE81B35C}"/>
              </a:ext>
            </a:extLst>
          </p:cNvPr>
          <p:cNvSpPr txBox="1"/>
          <p:nvPr/>
        </p:nvSpPr>
        <p:spPr>
          <a:xfrm>
            <a:off x="7638779" y="1233485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+</a:t>
            </a:r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615B6380-7E9B-4B89-B36A-38665690BA74}"/>
              </a:ext>
            </a:extLst>
          </p:cNvPr>
          <p:cNvSpPr txBox="1"/>
          <p:nvPr/>
        </p:nvSpPr>
        <p:spPr>
          <a:xfrm>
            <a:off x="6579730" y="1623897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+</a:t>
            </a:r>
            <a:endParaRPr lang="zh-CN" altLang="en-US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F740E8CF-C3C4-4C79-BD31-6317EFE0281A}"/>
              </a:ext>
            </a:extLst>
          </p:cNvPr>
          <p:cNvSpPr txBox="1"/>
          <p:nvPr/>
        </p:nvSpPr>
        <p:spPr>
          <a:xfrm>
            <a:off x="7676162" y="1650780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+</a:t>
            </a:r>
            <a:endParaRPr lang="zh-CN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23F31C65-09FE-479B-A757-DB7E1F4E3E11}"/>
              </a:ext>
            </a:extLst>
          </p:cNvPr>
          <p:cNvSpPr txBox="1"/>
          <p:nvPr/>
        </p:nvSpPr>
        <p:spPr>
          <a:xfrm>
            <a:off x="5504121" y="1241515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+</a:t>
            </a:r>
            <a:endParaRPr lang="zh-CN" altLang="en-US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1ED2F6AC-5E85-4C91-845B-6D58C86436A9}"/>
              </a:ext>
            </a:extLst>
          </p:cNvPr>
          <p:cNvSpPr txBox="1"/>
          <p:nvPr/>
        </p:nvSpPr>
        <p:spPr>
          <a:xfrm>
            <a:off x="4326210" y="1598496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-</a:t>
            </a:r>
            <a:endParaRPr lang="zh-CN" altLang="en-US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F17021B4-FF13-44A3-9DE0-74C53299EC5B}"/>
              </a:ext>
            </a:extLst>
          </p:cNvPr>
          <p:cNvSpPr txBox="1"/>
          <p:nvPr/>
        </p:nvSpPr>
        <p:spPr>
          <a:xfrm>
            <a:off x="4326210" y="1206227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-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900381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0F103C4D-8370-4F84-BFE1-19E8B3B399BB}"/>
              </a:ext>
            </a:extLst>
          </p:cNvPr>
          <p:cNvSpPr txBox="1"/>
          <p:nvPr/>
        </p:nvSpPr>
        <p:spPr>
          <a:xfrm>
            <a:off x="70386" y="5667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 4F</a:t>
            </a:r>
            <a:endParaRPr lang="zh-CN" altLang="en-US" dirty="0"/>
          </a:p>
        </p:txBody>
      </p:sp>
      <p:pic>
        <p:nvPicPr>
          <p:cNvPr id="5" name="图形 3">
            <a:extLst>
              <a:ext uri="{FF2B5EF4-FFF2-40B4-BE49-F238E27FC236}">
                <a16:creationId xmlns:a16="http://schemas.microsoft.com/office/drawing/2014/main" id="{5046C4C3-5A43-480C-A875-7B62E024DCB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08462" y="1853670"/>
            <a:ext cx="945143" cy="945184"/>
          </a:xfrm>
          <a:custGeom>
            <a:avLst/>
            <a:gdLst>
              <a:gd name="connsiteX0" fmla="*/ -165 w 945143"/>
              <a:gd name="connsiteY0" fmla="*/ -172 h 945184"/>
              <a:gd name="connsiteX1" fmla="*/ 944979 w 945143"/>
              <a:gd name="connsiteY1" fmla="*/ -172 h 945184"/>
              <a:gd name="connsiteX2" fmla="*/ 944979 w 945143"/>
              <a:gd name="connsiteY2" fmla="*/ 945013 h 945184"/>
              <a:gd name="connsiteX3" fmla="*/ -165 w 945143"/>
              <a:gd name="connsiteY3" fmla="*/ 945013 h 94518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45143" h="945184">
                <a:moveTo>
                  <a:pt x="-165" y="-172"/>
                </a:moveTo>
                <a:lnTo>
                  <a:pt x="944979" y="-172"/>
                </a:lnTo>
                <a:lnTo>
                  <a:pt x="944979" y="945013"/>
                </a:lnTo>
                <a:lnTo>
                  <a:pt x="-165" y="945013"/>
                </a:lnTo>
                <a:close/>
              </a:path>
            </a:pathLst>
          </a:custGeom>
        </p:spPr>
      </p:pic>
      <p:pic>
        <p:nvPicPr>
          <p:cNvPr id="6" name="图形 3">
            <a:extLst>
              <a:ext uri="{FF2B5EF4-FFF2-40B4-BE49-F238E27FC236}">
                <a16:creationId xmlns:a16="http://schemas.microsoft.com/office/drawing/2014/main" id="{5046C4C3-5A43-480C-A875-7B62E024DCB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42105" y="1853670"/>
            <a:ext cx="945143" cy="945184"/>
          </a:xfrm>
          <a:custGeom>
            <a:avLst/>
            <a:gdLst>
              <a:gd name="connsiteX0" fmla="*/ -56 w 945143"/>
              <a:gd name="connsiteY0" fmla="*/ -172 h 945184"/>
              <a:gd name="connsiteX1" fmla="*/ 945088 w 945143"/>
              <a:gd name="connsiteY1" fmla="*/ -172 h 945184"/>
              <a:gd name="connsiteX2" fmla="*/ 945088 w 945143"/>
              <a:gd name="connsiteY2" fmla="*/ 945013 h 945184"/>
              <a:gd name="connsiteX3" fmla="*/ -56 w 945143"/>
              <a:gd name="connsiteY3" fmla="*/ 945013 h 94518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45143" h="945184">
                <a:moveTo>
                  <a:pt x="-56" y="-172"/>
                </a:moveTo>
                <a:lnTo>
                  <a:pt x="945088" y="-172"/>
                </a:lnTo>
                <a:lnTo>
                  <a:pt x="945088" y="945013"/>
                </a:lnTo>
                <a:lnTo>
                  <a:pt x="-56" y="945013"/>
                </a:lnTo>
                <a:close/>
              </a:path>
            </a:pathLst>
          </a:custGeom>
        </p:spPr>
      </p:pic>
      <p:pic>
        <p:nvPicPr>
          <p:cNvPr id="7" name="图形 3">
            <a:extLst>
              <a:ext uri="{FF2B5EF4-FFF2-40B4-BE49-F238E27FC236}">
                <a16:creationId xmlns:a16="http://schemas.microsoft.com/office/drawing/2014/main" id="{5046C4C3-5A43-480C-A875-7B62E024DCB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67062" y="1853670"/>
            <a:ext cx="945143" cy="945184"/>
          </a:xfrm>
          <a:custGeom>
            <a:avLst/>
            <a:gdLst>
              <a:gd name="connsiteX0" fmla="*/ 51 w 945143"/>
              <a:gd name="connsiteY0" fmla="*/ -172 h 945184"/>
              <a:gd name="connsiteX1" fmla="*/ 945195 w 945143"/>
              <a:gd name="connsiteY1" fmla="*/ -172 h 945184"/>
              <a:gd name="connsiteX2" fmla="*/ 945195 w 945143"/>
              <a:gd name="connsiteY2" fmla="*/ 945013 h 945184"/>
              <a:gd name="connsiteX3" fmla="*/ 51 w 945143"/>
              <a:gd name="connsiteY3" fmla="*/ 945013 h 94518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45143" h="945184">
                <a:moveTo>
                  <a:pt x="51" y="-172"/>
                </a:moveTo>
                <a:lnTo>
                  <a:pt x="945195" y="-172"/>
                </a:lnTo>
                <a:lnTo>
                  <a:pt x="945195" y="945013"/>
                </a:lnTo>
                <a:lnTo>
                  <a:pt x="51" y="945013"/>
                </a:lnTo>
                <a:close/>
              </a:path>
            </a:pathLst>
          </a:custGeom>
        </p:spPr>
      </p:pic>
      <p:pic>
        <p:nvPicPr>
          <p:cNvPr id="8" name="图形 3">
            <a:extLst>
              <a:ext uri="{FF2B5EF4-FFF2-40B4-BE49-F238E27FC236}">
                <a16:creationId xmlns:a16="http://schemas.microsoft.com/office/drawing/2014/main" id="{5046C4C3-5A43-480C-A875-7B62E024DCB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288904" y="1853670"/>
            <a:ext cx="945143" cy="945184"/>
          </a:xfrm>
          <a:custGeom>
            <a:avLst/>
            <a:gdLst>
              <a:gd name="connsiteX0" fmla="*/ 159 w 945143"/>
              <a:gd name="connsiteY0" fmla="*/ -172 h 945184"/>
              <a:gd name="connsiteX1" fmla="*/ 945302 w 945143"/>
              <a:gd name="connsiteY1" fmla="*/ -172 h 945184"/>
              <a:gd name="connsiteX2" fmla="*/ 945302 w 945143"/>
              <a:gd name="connsiteY2" fmla="*/ 945013 h 945184"/>
              <a:gd name="connsiteX3" fmla="*/ 159 w 945143"/>
              <a:gd name="connsiteY3" fmla="*/ 945013 h 94518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45143" h="945184">
                <a:moveTo>
                  <a:pt x="159" y="-172"/>
                </a:moveTo>
                <a:lnTo>
                  <a:pt x="945302" y="-172"/>
                </a:lnTo>
                <a:lnTo>
                  <a:pt x="945302" y="945013"/>
                </a:lnTo>
                <a:lnTo>
                  <a:pt x="159" y="945013"/>
                </a:lnTo>
                <a:close/>
              </a:path>
            </a:pathLst>
          </a:custGeom>
        </p:spPr>
      </p:pic>
      <p:pic>
        <p:nvPicPr>
          <p:cNvPr id="9" name="图形 3">
            <a:extLst>
              <a:ext uri="{FF2B5EF4-FFF2-40B4-BE49-F238E27FC236}">
                <a16:creationId xmlns:a16="http://schemas.microsoft.com/office/drawing/2014/main" id="{5046C4C3-5A43-480C-A875-7B62E024DCB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208462" y="2864062"/>
            <a:ext cx="945143" cy="945184"/>
          </a:xfrm>
          <a:custGeom>
            <a:avLst/>
            <a:gdLst>
              <a:gd name="connsiteX0" fmla="*/ -165 w 945143"/>
              <a:gd name="connsiteY0" fmla="*/ -66 h 945184"/>
              <a:gd name="connsiteX1" fmla="*/ 944979 w 945143"/>
              <a:gd name="connsiteY1" fmla="*/ -66 h 945184"/>
              <a:gd name="connsiteX2" fmla="*/ 944979 w 945143"/>
              <a:gd name="connsiteY2" fmla="*/ 945119 h 945184"/>
              <a:gd name="connsiteX3" fmla="*/ -165 w 945143"/>
              <a:gd name="connsiteY3" fmla="*/ 945119 h 94518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45143" h="945184">
                <a:moveTo>
                  <a:pt x="-165" y="-66"/>
                </a:moveTo>
                <a:lnTo>
                  <a:pt x="944979" y="-66"/>
                </a:lnTo>
                <a:lnTo>
                  <a:pt x="944979" y="945119"/>
                </a:lnTo>
                <a:lnTo>
                  <a:pt x="-165" y="945119"/>
                </a:lnTo>
                <a:close/>
              </a:path>
            </a:pathLst>
          </a:custGeom>
        </p:spPr>
      </p:pic>
      <p:pic>
        <p:nvPicPr>
          <p:cNvPr id="10" name="图形 3">
            <a:extLst>
              <a:ext uri="{FF2B5EF4-FFF2-40B4-BE49-F238E27FC236}">
                <a16:creationId xmlns:a16="http://schemas.microsoft.com/office/drawing/2014/main" id="{5046C4C3-5A43-480C-A875-7B62E024DCB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242105" y="2864062"/>
            <a:ext cx="945143" cy="945184"/>
          </a:xfrm>
          <a:custGeom>
            <a:avLst/>
            <a:gdLst>
              <a:gd name="connsiteX0" fmla="*/ -56 w 945143"/>
              <a:gd name="connsiteY0" fmla="*/ -66 h 945184"/>
              <a:gd name="connsiteX1" fmla="*/ 945088 w 945143"/>
              <a:gd name="connsiteY1" fmla="*/ -66 h 945184"/>
              <a:gd name="connsiteX2" fmla="*/ 945088 w 945143"/>
              <a:gd name="connsiteY2" fmla="*/ 945119 h 945184"/>
              <a:gd name="connsiteX3" fmla="*/ -56 w 945143"/>
              <a:gd name="connsiteY3" fmla="*/ 945119 h 94518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45143" h="945184">
                <a:moveTo>
                  <a:pt x="-56" y="-66"/>
                </a:moveTo>
                <a:lnTo>
                  <a:pt x="945088" y="-66"/>
                </a:lnTo>
                <a:lnTo>
                  <a:pt x="945088" y="945119"/>
                </a:lnTo>
                <a:lnTo>
                  <a:pt x="-56" y="945119"/>
                </a:lnTo>
                <a:close/>
              </a:path>
            </a:pathLst>
          </a:custGeom>
        </p:spPr>
      </p:pic>
      <p:pic>
        <p:nvPicPr>
          <p:cNvPr id="11" name="图形 3">
            <a:extLst>
              <a:ext uri="{FF2B5EF4-FFF2-40B4-BE49-F238E27FC236}">
                <a16:creationId xmlns:a16="http://schemas.microsoft.com/office/drawing/2014/main" id="{5046C4C3-5A43-480C-A875-7B62E024DCB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267062" y="2864062"/>
            <a:ext cx="945143" cy="945184"/>
          </a:xfrm>
          <a:custGeom>
            <a:avLst/>
            <a:gdLst>
              <a:gd name="connsiteX0" fmla="*/ 51 w 945143"/>
              <a:gd name="connsiteY0" fmla="*/ -66 h 945184"/>
              <a:gd name="connsiteX1" fmla="*/ 945195 w 945143"/>
              <a:gd name="connsiteY1" fmla="*/ -66 h 945184"/>
              <a:gd name="connsiteX2" fmla="*/ 945195 w 945143"/>
              <a:gd name="connsiteY2" fmla="*/ 945119 h 945184"/>
              <a:gd name="connsiteX3" fmla="*/ 51 w 945143"/>
              <a:gd name="connsiteY3" fmla="*/ 945119 h 94518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45143" h="945184">
                <a:moveTo>
                  <a:pt x="51" y="-66"/>
                </a:moveTo>
                <a:lnTo>
                  <a:pt x="945195" y="-66"/>
                </a:lnTo>
                <a:lnTo>
                  <a:pt x="945195" y="945119"/>
                </a:lnTo>
                <a:lnTo>
                  <a:pt x="51" y="945119"/>
                </a:lnTo>
                <a:close/>
              </a:path>
            </a:pathLst>
          </a:custGeom>
        </p:spPr>
      </p:pic>
      <p:pic>
        <p:nvPicPr>
          <p:cNvPr id="12" name="图形 3">
            <a:extLst>
              <a:ext uri="{FF2B5EF4-FFF2-40B4-BE49-F238E27FC236}">
                <a16:creationId xmlns:a16="http://schemas.microsoft.com/office/drawing/2014/main" id="{5046C4C3-5A43-480C-A875-7B62E024DCB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288904" y="2864062"/>
            <a:ext cx="945143" cy="945184"/>
          </a:xfrm>
          <a:custGeom>
            <a:avLst/>
            <a:gdLst>
              <a:gd name="connsiteX0" fmla="*/ 159 w 945143"/>
              <a:gd name="connsiteY0" fmla="*/ -66 h 945184"/>
              <a:gd name="connsiteX1" fmla="*/ 945302 w 945143"/>
              <a:gd name="connsiteY1" fmla="*/ -66 h 945184"/>
              <a:gd name="connsiteX2" fmla="*/ 945302 w 945143"/>
              <a:gd name="connsiteY2" fmla="*/ 945119 h 945184"/>
              <a:gd name="connsiteX3" fmla="*/ 159 w 945143"/>
              <a:gd name="connsiteY3" fmla="*/ 945119 h 94518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45143" h="945184">
                <a:moveTo>
                  <a:pt x="159" y="-66"/>
                </a:moveTo>
                <a:lnTo>
                  <a:pt x="945302" y="-66"/>
                </a:lnTo>
                <a:lnTo>
                  <a:pt x="945302" y="945119"/>
                </a:lnTo>
                <a:lnTo>
                  <a:pt x="159" y="945119"/>
                </a:lnTo>
                <a:close/>
              </a:path>
            </a:pathLst>
          </a:custGeom>
        </p:spPr>
      </p:pic>
      <p:pic>
        <p:nvPicPr>
          <p:cNvPr id="13" name="图形 3">
            <a:extLst>
              <a:ext uri="{FF2B5EF4-FFF2-40B4-BE49-F238E27FC236}">
                <a16:creationId xmlns:a16="http://schemas.microsoft.com/office/drawing/2014/main" id="{5046C4C3-5A43-480C-A875-7B62E024DCBB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208462" y="3872931"/>
            <a:ext cx="945143" cy="945184"/>
          </a:xfrm>
          <a:custGeom>
            <a:avLst/>
            <a:gdLst>
              <a:gd name="connsiteX0" fmla="*/ -165 w 945143"/>
              <a:gd name="connsiteY0" fmla="*/ 40 h 945184"/>
              <a:gd name="connsiteX1" fmla="*/ 944979 w 945143"/>
              <a:gd name="connsiteY1" fmla="*/ 40 h 945184"/>
              <a:gd name="connsiteX2" fmla="*/ 944979 w 945143"/>
              <a:gd name="connsiteY2" fmla="*/ 945225 h 945184"/>
              <a:gd name="connsiteX3" fmla="*/ -165 w 945143"/>
              <a:gd name="connsiteY3" fmla="*/ 945225 h 94518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45143" h="945184">
                <a:moveTo>
                  <a:pt x="-165" y="40"/>
                </a:moveTo>
                <a:lnTo>
                  <a:pt x="944979" y="40"/>
                </a:lnTo>
                <a:lnTo>
                  <a:pt x="944979" y="945225"/>
                </a:lnTo>
                <a:lnTo>
                  <a:pt x="-165" y="945225"/>
                </a:lnTo>
                <a:close/>
              </a:path>
            </a:pathLst>
          </a:custGeom>
        </p:spPr>
      </p:pic>
      <p:pic>
        <p:nvPicPr>
          <p:cNvPr id="14" name="图形 3">
            <a:extLst>
              <a:ext uri="{FF2B5EF4-FFF2-40B4-BE49-F238E27FC236}">
                <a16:creationId xmlns:a16="http://schemas.microsoft.com/office/drawing/2014/main" id="{5046C4C3-5A43-480C-A875-7B62E024DCBB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242105" y="3872931"/>
            <a:ext cx="945143" cy="945184"/>
          </a:xfrm>
          <a:custGeom>
            <a:avLst/>
            <a:gdLst>
              <a:gd name="connsiteX0" fmla="*/ -56 w 945143"/>
              <a:gd name="connsiteY0" fmla="*/ 40 h 945184"/>
              <a:gd name="connsiteX1" fmla="*/ 945088 w 945143"/>
              <a:gd name="connsiteY1" fmla="*/ 40 h 945184"/>
              <a:gd name="connsiteX2" fmla="*/ 945088 w 945143"/>
              <a:gd name="connsiteY2" fmla="*/ 945225 h 945184"/>
              <a:gd name="connsiteX3" fmla="*/ -56 w 945143"/>
              <a:gd name="connsiteY3" fmla="*/ 945225 h 94518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45143" h="945184">
                <a:moveTo>
                  <a:pt x="-56" y="40"/>
                </a:moveTo>
                <a:lnTo>
                  <a:pt x="945088" y="40"/>
                </a:lnTo>
                <a:lnTo>
                  <a:pt x="945088" y="945225"/>
                </a:lnTo>
                <a:lnTo>
                  <a:pt x="-56" y="945225"/>
                </a:lnTo>
                <a:close/>
              </a:path>
            </a:pathLst>
          </a:custGeom>
        </p:spPr>
      </p:pic>
      <p:pic>
        <p:nvPicPr>
          <p:cNvPr id="15" name="图形 3">
            <a:extLst>
              <a:ext uri="{FF2B5EF4-FFF2-40B4-BE49-F238E27FC236}">
                <a16:creationId xmlns:a16="http://schemas.microsoft.com/office/drawing/2014/main" id="{5046C4C3-5A43-480C-A875-7B62E024DCBB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6267062" y="3872931"/>
            <a:ext cx="945143" cy="945184"/>
          </a:xfrm>
          <a:custGeom>
            <a:avLst/>
            <a:gdLst>
              <a:gd name="connsiteX0" fmla="*/ 51 w 945143"/>
              <a:gd name="connsiteY0" fmla="*/ 40 h 945184"/>
              <a:gd name="connsiteX1" fmla="*/ 945195 w 945143"/>
              <a:gd name="connsiteY1" fmla="*/ 40 h 945184"/>
              <a:gd name="connsiteX2" fmla="*/ 945195 w 945143"/>
              <a:gd name="connsiteY2" fmla="*/ 945225 h 945184"/>
              <a:gd name="connsiteX3" fmla="*/ 51 w 945143"/>
              <a:gd name="connsiteY3" fmla="*/ 945225 h 94518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45143" h="945184">
                <a:moveTo>
                  <a:pt x="51" y="40"/>
                </a:moveTo>
                <a:lnTo>
                  <a:pt x="945195" y="40"/>
                </a:lnTo>
                <a:lnTo>
                  <a:pt x="945195" y="945225"/>
                </a:lnTo>
                <a:lnTo>
                  <a:pt x="51" y="945225"/>
                </a:lnTo>
                <a:close/>
              </a:path>
            </a:pathLst>
          </a:custGeom>
        </p:spPr>
      </p:pic>
      <p:pic>
        <p:nvPicPr>
          <p:cNvPr id="16" name="图形 3">
            <a:extLst>
              <a:ext uri="{FF2B5EF4-FFF2-40B4-BE49-F238E27FC236}">
                <a16:creationId xmlns:a16="http://schemas.microsoft.com/office/drawing/2014/main" id="{5046C4C3-5A43-480C-A875-7B62E024DCBB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7288904" y="3872931"/>
            <a:ext cx="945143" cy="945184"/>
          </a:xfrm>
          <a:custGeom>
            <a:avLst/>
            <a:gdLst>
              <a:gd name="connsiteX0" fmla="*/ 159 w 945143"/>
              <a:gd name="connsiteY0" fmla="*/ 40 h 945184"/>
              <a:gd name="connsiteX1" fmla="*/ 945302 w 945143"/>
              <a:gd name="connsiteY1" fmla="*/ 40 h 945184"/>
              <a:gd name="connsiteX2" fmla="*/ 945302 w 945143"/>
              <a:gd name="connsiteY2" fmla="*/ 945225 h 945184"/>
              <a:gd name="connsiteX3" fmla="*/ 159 w 945143"/>
              <a:gd name="connsiteY3" fmla="*/ 945225 h 94518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45143" h="945184">
                <a:moveTo>
                  <a:pt x="159" y="40"/>
                </a:moveTo>
                <a:lnTo>
                  <a:pt x="945302" y="40"/>
                </a:lnTo>
                <a:lnTo>
                  <a:pt x="945302" y="945225"/>
                </a:lnTo>
                <a:lnTo>
                  <a:pt x="159" y="945225"/>
                </a:lnTo>
                <a:close/>
              </a:path>
            </a:pathLst>
          </a:custGeom>
        </p:spPr>
      </p:pic>
      <p:sp>
        <p:nvSpPr>
          <p:cNvPr id="69" name="文本框 68">
            <a:extLst>
              <a:ext uri="{FF2B5EF4-FFF2-40B4-BE49-F238E27FC236}">
                <a16:creationId xmlns:a16="http://schemas.microsoft.com/office/drawing/2014/main" id="{64477CF3-C75A-4AF9-AC1A-8CC1F2B26E73}"/>
              </a:ext>
            </a:extLst>
          </p:cNvPr>
          <p:cNvSpPr txBox="1"/>
          <p:nvPr/>
        </p:nvSpPr>
        <p:spPr>
          <a:xfrm>
            <a:off x="2219302" y="3059668"/>
            <a:ext cx="17287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pHBLV</a:t>
            </a:r>
            <a:r>
              <a:rPr lang="en-US" altLang="zh-CN" dirty="0"/>
              <a:t> sestrin2</a:t>
            </a:r>
            <a:endParaRPr lang="zh-CN" altLang="en-US" dirty="0"/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FA68E0D1-72F0-4FBA-BC78-25DF075CE6D3}"/>
              </a:ext>
            </a:extLst>
          </p:cNvPr>
          <p:cNvSpPr txBox="1"/>
          <p:nvPr/>
        </p:nvSpPr>
        <p:spPr>
          <a:xfrm>
            <a:off x="2467178" y="1081697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Dox</a:t>
            </a:r>
            <a:endParaRPr lang="zh-CN" altLang="en-US" dirty="0"/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9D1957F8-141A-4DA8-A872-F02A7EA15470}"/>
              </a:ext>
            </a:extLst>
          </p:cNvPr>
          <p:cNvSpPr txBox="1"/>
          <p:nvPr/>
        </p:nvSpPr>
        <p:spPr>
          <a:xfrm>
            <a:off x="2467178" y="1431430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3-MA</a:t>
            </a:r>
            <a:endParaRPr lang="zh-CN" altLang="en-US" dirty="0"/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88259B16-F47A-45A6-BA79-3A12059D5A60}"/>
              </a:ext>
            </a:extLst>
          </p:cNvPr>
          <p:cNvSpPr txBox="1"/>
          <p:nvPr/>
        </p:nvSpPr>
        <p:spPr>
          <a:xfrm>
            <a:off x="6596852" y="1048234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-</a:t>
            </a:r>
            <a:endParaRPr lang="zh-CN" altLang="en-US" dirty="0"/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FF693769-69B8-411A-8A44-211569F9698D}"/>
              </a:ext>
            </a:extLst>
          </p:cNvPr>
          <p:cNvSpPr txBox="1"/>
          <p:nvPr/>
        </p:nvSpPr>
        <p:spPr>
          <a:xfrm>
            <a:off x="5554570" y="1441949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-</a:t>
            </a:r>
            <a:endParaRPr lang="zh-CN" altLang="en-US" dirty="0"/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6898F3C0-E4F6-4D68-80D9-D727A8AA93A7}"/>
              </a:ext>
            </a:extLst>
          </p:cNvPr>
          <p:cNvSpPr txBox="1"/>
          <p:nvPr/>
        </p:nvSpPr>
        <p:spPr>
          <a:xfrm>
            <a:off x="7655713" y="1072618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+</a:t>
            </a:r>
            <a:endParaRPr lang="zh-CN" altLang="en-US" dirty="0"/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B7F5713D-1302-46A0-8DB9-9802CA234F8A}"/>
              </a:ext>
            </a:extLst>
          </p:cNvPr>
          <p:cNvSpPr txBox="1"/>
          <p:nvPr/>
        </p:nvSpPr>
        <p:spPr>
          <a:xfrm>
            <a:off x="6596664" y="1463030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+</a:t>
            </a:r>
            <a:endParaRPr lang="zh-CN" altLang="en-US" dirty="0"/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CC00E074-3FE8-482C-8870-8DA40F2B4BE8}"/>
              </a:ext>
            </a:extLst>
          </p:cNvPr>
          <p:cNvSpPr txBox="1"/>
          <p:nvPr/>
        </p:nvSpPr>
        <p:spPr>
          <a:xfrm>
            <a:off x="7693096" y="148991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+</a:t>
            </a:r>
            <a:endParaRPr lang="zh-CN" altLang="en-US" dirty="0"/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8FE9C503-F767-4E50-8234-425EA780CAD9}"/>
              </a:ext>
            </a:extLst>
          </p:cNvPr>
          <p:cNvSpPr txBox="1"/>
          <p:nvPr/>
        </p:nvSpPr>
        <p:spPr>
          <a:xfrm>
            <a:off x="5521055" y="1080648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+</a:t>
            </a:r>
            <a:endParaRPr lang="zh-CN" altLang="en-US" dirty="0"/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CD9B70FE-51A5-40F1-9A5A-088C81305F20}"/>
              </a:ext>
            </a:extLst>
          </p:cNvPr>
          <p:cNvSpPr txBox="1"/>
          <p:nvPr/>
        </p:nvSpPr>
        <p:spPr>
          <a:xfrm>
            <a:off x="4563278" y="1437629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-</a:t>
            </a:r>
            <a:endParaRPr lang="zh-CN" altLang="en-US" dirty="0"/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58FA9461-A7F8-4F1F-AF79-0A6FC7C75E57}"/>
              </a:ext>
            </a:extLst>
          </p:cNvPr>
          <p:cNvSpPr txBox="1"/>
          <p:nvPr/>
        </p:nvSpPr>
        <p:spPr>
          <a:xfrm>
            <a:off x="4563278" y="1045360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-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8083192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271E23C0-33A0-41C3-8C4A-34E02FD55128}"/>
              </a:ext>
            </a:extLst>
          </p:cNvPr>
          <p:cNvSpPr txBox="1"/>
          <p:nvPr/>
        </p:nvSpPr>
        <p:spPr>
          <a:xfrm>
            <a:off x="70386" y="5667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 4F</a:t>
            </a:r>
            <a:endParaRPr lang="zh-CN" altLang="en-US" dirty="0"/>
          </a:p>
        </p:txBody>
      </p:sp>
      <p:pic>
        <p:nvPicPr>
          <p:cNvPr id="3" name="图形 3">
            <a:extLst>
              <a:ext uri="{FF2B5EF4-FFF2-40B4-BE49-F238E27FC236}">
                <a16:creationId xmlns:a16="http://schemas.microsoft.com/office/drawing/2014/main" id="{30A6BFD0-FF88-4452-B1D9-1C995EF24CB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42331" y="1888276"/>
            <a:ext cx="945143" cy="945184"/>
          </a:xfrm>
          <a:custGeom>
            <a:avLst/>
            <a:gdLst>
              <a:gd name="connsiteX0" fmla="*/ -165 w 945143"/>
              <a:gd name="connsiteY0" fmla="*/ 180 h 945184"/>
              <a:gd name="connsiteX1" fmla="*/ 944979 w 945143"/>
              <a:gd name="connsiteY1" fmla="*/ 180 h 945184"/>
              <a:gd name="connsiteX2" fmla="*/ 944979 w 945143"/>
              <a:gd name="connsiteY2" fmla="*/ 945365 h 945184"/>
              <a:gd name="connsiteX3" fmla="*/ -165 w 945143"/>
              <a:gd name="connsiteY3" fmla="*/ 945365 h 94518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45143" h="945184">
                <a:moveTo>
                  <a:pt x="-165" y="180"/>
                </a:moveTo>
                <a:lnTo>
                  <a:pt x="944979" y="180"/>
                </a:lnTo>
                <a:lnTo>
                  <a:pt x="944979" y="945365"/>
                </a:lnTo>
                <a:lnTo>
                  <a:pt x="-165" y="945365"/>
                </a:lnTo>
                <a:close/>
              </a:path>
            </a:pathLst>
          </a:custGeom>
        </p:spPr>
      </p:pic>
      <p:pic>
        <p:nvPicPr>
          <p:cNvPr id="4" name="图形 3">
            <a:extLst>
              <a:ext uri="{FF2B5EF4-FFF2-40B4-BE49-F238E27FC236}">
                <a16:creationId xmlns:a16="http://schemas.microsoft.com/office/drawing/2014/main" id="{126164F1-ED9E-4E6B-8A4C-55D74963AFD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75974" y="1888276"/>
            <a:ext cx="945143" cy="945184"/>
          </a:xfrm>
          <a:custGeom>
            <a:avLst/>
            <a:gdLst>
              <a:gd name="connsiteX0" fmla="*/ -56 w 945143"/>
              <a:gd name="connsiteY0" fmla="*/ 180 h 945184"/>
              <a:gd name="connsiteX1" fmla="*/ 945088 w 945143"/>
              <a:gd name="connsiteY1" fmla="*/ 180 h 945184"/>
              <a:gd name="connsiteX2" fmla="*/ 945088 w 945143"/>
              <a:gd name="connsiteY2" fmla="*/ 945365 h 945184"/>
              <a:gd name="connsiteX3" fmla="*/ -56 w 945143"/>
              <a:gd name="connsiteY3" fmla="*/ 945365 h 94518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45143" h="945184">
                <a:moveTo>
                  <a:pt x="-56" y="180"/>
                </a:moveTo>
                <a:lnTo>
                  <a:pt x="945088" y="180"/>
                </a:lnTo>
                <a:lnTo>
                  <a:pt x="945088" y="945365"/>
                </a:lnTo>
                <a:lnTo>
                  <a:pt x="-56" y="945365"/>
                </a:lnTo>
                <a:close/>
              </a:path>
            </a:pathLst>
          </a:custGeom>
        </p:spPr>
      </p:pic>
      <p:pic>
        <p:nvPicPr>
          <p:cNvPr id="5" name="图形 3">
            <a:extLst>
              <a:ext uri="{FF2B5EF4-FFF2-40B4-BE49-F238E27FC236}">
                <a16:creationId xmlns:a16="http://schemas.microsoft.com/office/drawing/2014/main" id="{D30B8C4D-56D6-46D4-BB07-8736E400C0F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00931" y="1888276"/>
            <a:ext cx="945143" cy="945184"/>
          </a:xfrm>
          <a:custGeom>
            <a:avLst/>
            <a:gdLst>
              <a:gd name="connsiteX0" fmla="*/ 51 w 945143"/>
              <a:gd name="connsiteY0" fmla="*/ 180 h 945184"/>
              <a:gd name="connsiteX1" fmla="*/ 945195 w 945143"/>
              <a:gd name="connsiteY1" fmla="*/ 180 h 945184"/>
              <a:gd name="connsiteX2" fmla="*/ 945195 w 945143"/>
              <a:gd name="connsiteY2" fmla="*/ 945365 h 945184"/>
              <a:gd name="connsiteX3" fmla="*/ 51 w 945143"/>
              <a:gd name="connsiteY3" fmla="*/ 945365 h 94518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45143" h="945184">
                <a:moveTo>
                  <a:pt x="51" y="180"/>
                </a:moveTo>
                <a:lnTo>
                  <a:pt x="945195" y="180"/>
                </a:lnTo>
                <a:lnTo>
                  <a:pt x="945195" y="945365"/>
                </a:lnTo>
                <a:lnTo>
                  <a:pt x="51" y="945365"/>
                </a:lnTo>
                <a:close/>
              </a:path>
            </a:pathLst>
          </a:custGeom>
        </p:spPr>
      </p:pic>
      <p:pic>
        <p:nvPicPr>
          <p:cNvPr id="6" name="图形 3">
            <a:extLst>
              <a:ext uri="{FF2B5EF4-FFF2-40B4-BE49-F238E27FC236}">
                <a16:creationId xmlns:a16="http://schemas.microsoft.com/office/drawing/2014/main" id="{77326416-909F-4FE4-80A7-E36DA892262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322773" y="1888276"/>
            <a:ext cx="945143" cy="945184"/>
          </a:xfrm>
          <a:custGeom>
            <a:avLst/>
            <a:gdLst>
              <a:gd name="connsiteX0" fmla="*/ 159 w 945143"/>
              <a:gd name="connsiteY0" fmla="*/ 180 h 945184"/>
              <a:gd name="connsiteX1" fmla="*/ 945302 w 945143"/>
              <a:gd name="connsiteY1" fmla="*/ 180 h 945184"/>
              <a:gd name="connsiteX2" fmla="*/ 945302 w 945143"/>
              <a:gd name="connsiteY2" fmla="*/ 945365 h 945184"/>
              <a:gd name="connsiteX3" fmla="*/ 159 w 945143"/>
              <a:gd name="connsiteY3" fmla="*/ 945365 h 94518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45143" h="945184">
                <a:moveTo>
                  <a:pt x="159" y="180"/>
                </a:moveTo>
                <a:lnTo>
                  <a:pt x="945302" y="180"/>
                </a:lnTo>
                <a:lnTo>
                  <a:pt x="945302" y="945365"/>
                </a:lnTo>
                <a:lnTo>
                  <a:pt x="159" y="945365"/>
                </a:lnTo>
                <a:close/>
              </a:path>
            </a:pathLst>
          </a:custGeom>
        </p:spPr>
      </p:pic>
      <p:pic>
        <p:nvPicPr>
          <p:cNvPr id="7" name="图形 3">
            <a:extLst>
              <a:ext uri="{FF2B5EF4-FFF2-40B4-BE49-F238E27FC236}">
                <a16:creationId xmlns:a16="http://schemas.microsoft.com/office/drawing/2014/main" id="{10B77C56-5110-48BF-A45E-9BDF785E72A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242331" y="2907994"/>
            <a:ext cx="945143" cy="945184"/>
          </a:xfrm>
          <a:custGeom>
            <a:avLst/>
            <a:gdLst>
              <a:gd name="connsiteX0" fmla="*/ -165 w 945143"/>
              <a:gd name="connsiteY0" fmla="*/ 287 h 945184"/>
              <a:gd name="connsiteX1" fmla="*/ 944979 w 945143"/>
              <a:gd name="connsiteY1" fmla="*/ 287 h 945184"/>
              <a:gd name="connsiteX2" fmla="*/ 944979 w 945143"/>
              <a:gd name="connsiteY2" fmla="*/ 945472 h 945184"/>
              <a:gd name="connsiteX3" fmla="*/ -165 w 945143"/>
              <a:gd name="connsiteY3" fmla="*/ 945472 h 94518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45143" h="945184">
                <a:moveTo>
                  <a:pt x="-165" y="287"/>
                </a:moveTo>
                <a:lnTo>
                  <a:pt x="944979" y="287"/>
                </a:lnTo>
                <a:lnTo>
                  <a:pt x="944979" y="945472"/>
                </a:lnTo>
                <a:lnTo>
                  <a:pt x="-165" y="945472"/>
                </a:lnTo>
                <a:close/>
              </a:path>
            </a:pathLst>
          </a:custGeom>
        </p:spPr>
      </p:pic>
      <p:pic>
        <p:nvPicPr>
          <p:cNvPr id="8" name="图形 3">
            <a:extLst>
              <a:ext uri="{FF2B5EF4-FFF2-40B4-BE49-F238E27FC236}">
                <a16:creationId xmlns:a16="http://schemas.microsoft.com/office/drawing/2014/main" id="{C0199B93-F579-429D-928F-C4F63234AFF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275974" y="2907994"/>
            <a:ext cx="945143" cy="945184"/>
          </a:xfrm>
          <a:custGeom>
            <a:avLst/>
            <a:gdLst>
              <a:gd name="connsiteX0" fmla="*/ -56 w 945143"/>
              <a:gd name="connsiteY0" fmla="*/ 287 h 945184"/>
              <a:gd name="connsiteX1" fmla="*/ 945088 w 945143"/>
              <a:gd name="connsiteY1" fmla="*/ 287 h 945184"/>
              <a:gd name="connsiteX2" fmla="*/ 945088 w 945143"/>
              <a:gd name="connsiteY2" fmla="*/ 945472 h 945184"/>
              <a:gd name="connsiteX3" fmla="*/ -56 w 945143"/>
              <a:gd name="connsiteY3" fmla="*/ 945472 h 94518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45143" h="945184">
                <a:moveTo>
                  <a:pt x="-56" y="287"/>
                </a:moveTo>
                <a:lnTo>
                  <a:pt x="945088" y="287"/>
                </a:lnTo>
                <a:lnTo>
                  <a:pt x="945088" y="945472"/>
                </a:lnTo>
                <a:lnTo>
                  <a:pt x="-56" y="945472"/>
                </a:lnTo>
                <a:close/>
              </a:path>
            </a:pathLst>
          </a:custGeom>
        </p:spPr>
      </p:pic>
      <p:pic>
        <p:nvPicPr>
          <p:cNvPr id="9" name="图形 3">
            <a:extLst>
              <a:ext uri="{FF2B5EF4-FFF2-40B4-BE49-F238E27FC236}">
                <a16:creationId xmlns:a16="http://schemas.microsoft.com/office/drawing/2014/main" id="{C083A7DF-8728-4EF8-82F5-1B0EE3B39B6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300931" y="2907994"/>
            <a:ext cx="945143" cy="945184"/>
          </a:xfrm>
          <a:custGeom>
            <a:avLst/>
            <a:gdLst>
              <a:gd name="connsiteX0" fmla="*/ 51 w 945143"/>
              <a:gd name="connsiteY0" fmla="*/ 287 h 945184"/>
              <a:gd name="connsiteX1" fmla="*/ 945195 w 945143"/>
              <a:gd name="connsiteY1" fmla="*/ 287 h 945184"/>
              <a:gd name="connsiteX2" fmla="*/ 945195 w 945143"/>
              <a:gd name="connsiteY2" fmla="*/ 945472 h 945184"/>
              <a:gd name="connsiteX3" fmla="*/ 51 w 945143"/>
              <a:gd name="connsiteY3" fmla="*/ 945472 h 94518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45143" h="945184">
                <a:moveTo>
                  <a:pt x="51" y="287"/>
                </a:moveTo>
                <a:lnTo>
                  <a:pt x="945195" y="287"/>
                </a:lnTo>
                <a:lnTo>
                  <a:pt x="945195" y="945472"/>
                </a:lnTo>
                <a:lnTo>
                  <a:pt x="51" y="945472"/>
                </a:lnTo>
                <a:close/>
              </a:path>
            </a:pathLst>
          </a:custGeom>
        </p:spPr>
      </p:pic>
      <p:pic>
        <p:nvPicPr>
          <p:cNvPr id="10" name="图形 3">
            <a:extLst>
              <a:ext uri="{FF2B5EF4-FFF2-40B4-BE49-F238E27FC236}">
                <a16:creationId xmlns:a16="http://schemas.microsoft.com/office/drawing/2014/main" id="{40D4796C-0460-41FB-9A68-14F761CC874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322773" y="2907994"/>
            <a:ext cx="945143" cy="945184"/>
          </a:xfrm>
          <a:custGeom>
            <a:avLst/>
            <a:gdLst>
              <a:gd name="connsiteX0" fmla="*/ 159 w 945143"/>
              <a:gd name="connsiteY0" fmla="*/ 287 h 945184"/>
              <a:gd name="connsiteX1" fmla="*/ 945302 w 945143"/>
              <a:gd name="connsiteY1" fmla="*/ 287 h 945184"/>
              <a:gd name="connsiteX2" fmla="*/ 945302 w 945143"/>
              <a:gd name="connsiteY2" fmla="*/ 945472 h 945184"/>
              <a:gd name="connsiteX3" fmla="*/ 159 w 945143"/>
              <a:gd name="connsiteY3" fmla="*/ 945472 h 94518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45143" h="945184">
                <a:moveTo>
                  <a:pt x="159" y="287"/>
                </a:moveTo>
                <a:lnTo>
                  <a:pt x="945302" y="287"/>
                </a:lnTo>
                <a:lnTo>
                  <a:pt x="945302" y="945472"/>
                </a:lnTo>
                <a:lnTo>
                  <a:pt x="159" y="945472"/>
                </a:lnTo>
                <a:close/>
              </a:path>
            </a:pathLst>
          </a:custGeom>
        </p:spPr>
      </p:pic>
      <p:pic>
        <p:nvPicPr>
          <p:cNvPr id="11" name="图形 3">
            <a:extLst>
              <a:ext uri="{FF2B5EF4-FFF2-40B4-BE49-F238E27FC236}">
                <a16:creationId xmlns:a16="http://schemas.microsoft.com/office/drawing/2014/main" id="{49260FCC-A608-4A86-B21A-46B6A71C8C04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242331" y="3920454"/>
            <a:ext cx="945143" cy="945184"/>
          </a:xfrm>
          <a:custGeom>
            <a:avLst/>
            <a:gdLst>
              <a:gd name="connsiteX0" fmla="*/ -165 w 945143"/>
              <a:gd name="connsiteY0" fmla="*/ 394 h 945184"/>
              <a:gd name="connsiteX1" fmla="*/ 944979 w 945143"/>
              <a:gd name="connsiteY1" fmla="*/ 394 h 945184"/>
              <a:gd name="connsiteX2" fmla="*/ 944979 w 945143"/>
              <a:gd name="connsiteY2" fmla="*/ 945578 h 945184"/>
              <a:gd name="connsiteX3" fmla="*/ -165 w 945143"/>
              <a:gd name="connsiteY3" fmla="*/ 945578 h 94518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45143" h="945184">
                <a:moveTo>
                  <a:pt x="-165" y="394"/>
                </a:moveTo>
                <a:lnTo>
                  <a:pt x="944979" y="394"/>
                </a:lnTo>
                <a:lnTo>
                  <a:pt x="944979" y="945578"/>
                </a:lnTo>
                <a:lnTo>
                  <a:pt x="-165" y="945578"/>
                </a:lnTo>
                <a:close/>
              </a:path>
            </a:pathLst>
          </a:custGeom>
        </p:spPr>
      </p:pic>
      <p:pic>
        <p:nvPicPr>
          <p:cNvPr id="12" name="图形 3">
            <a:extLst>
              <a:ext uri="{FF2B5EF4-FFF2-40B4-BE49-F238E27FC236}">
                <a16:creationId xmlns:a16="http://schemas.microsoft.com/office/drawing/2014/main" id="{08979337-1180-45DF-9348-FB27B7946B27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275974" y="3920454"/>
            <a:ext cx="945143" cy="945184"/>
          </a:xfrm>
          <a:custGeom>
            <a:avLst/>
            <a:gdLst>
              <a:gd name="connsiteX0" fmla="*/ -56 w 945143"/>
              <a:gd name="connsiteY0" fmla="*/ 394 h 945184"/>
              <a:gd name="connsiteX1" fmla="*/ 945088 w 945143"/>
              <a:gd name="connsiteY1" fmla="*/ 394 h 945184"/>
              <a:gd name="connsiteX2" fmla="*/ 945088 w 945143"/>
              <a:gd name="connsiteY2" fmla="*/ 945578 h 945184"/>
              <a:gd name="connsiteX3" fmla="*/ -56 w 945143"/>
              <a:gd name="connsiteY3" fmla="*/ 945578 h 94518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45143" h="945184">
                <a:moveTo>
                  <a:pt x="-56" y="394"/>
                </a:moveTo>
                <a:lnTo>
                  <a:pt x="945088" y="394"/>
                </a:lnTo>
                <a:lnTo>
                  <a:pt x="945088" y="945578"/>
                </a:lnTo>
                <a:lnTo>
                  <a:pt x="-56" y="945578"/>
                </a:lnTo>
                <a:close/>
              </a:path>
            </a:pathLst>
          </a:custGeom>
        </p:spPr>
      </p:pic>
      <p:pic>
        <p:nvPicPr>
          <p:cNvPr id="13" name="图形 3">
            <a:extLst>
              <a:ext uri="{FF2B5EF4-FFF2-40B4-BE49-F238E27FC236}">
                <a16:creationId xmlns:a16="http://schemas.microsoft.com/office/drawing/2014/main" id="{56598409-9C80-42CA-BD8C-908E3330ADAE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6300931" y="3920454"/>
            <a:ext cx="945143" cy="945184"/>
          </a:xfrm>
          <a:custGeom>
            <a:avLst/>
            <a:gdLst>
              <a:gd name="connsiteX0" fmla="*/ 51 w 945143"/>
              <a:gd name="connsiteY0" fmla="*/ 394 h 945184"/>
              <a:gd name="connsiteX1" fmla="*/ 945195 w 945143"/>
              <a:gd name="connsiteY1" fmla="*/ 394 h 945184"/>
              <a:gd name="connsiteX2" fmla="*/ 945195 w 945143"/>
              <a:gd name="connsiteY2" fmla="*/ 945578 h 945184"/>
              <a:gd name="connsiteX3" fmla="*/ 51 w 945143"/>
              <a:gd name="connsiteY3" fmla="*/ 945578 h 94518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45143" h="945184">
                <a:moveTo>
                  <a:pt x="51" y="394"/>
                </a:moveTo>
                <a:lnTo>
                  <a:pt x="945195" y="394"/>
                </a:lnTo>
                <a:lnTo>
                  <a:pt x="945195" y="945578"/>
                </a:lnTo>
                <a:lnTo>
                  <a:pt x="51" y="945578"/>
                </a:lnTo>
                <a:close/>
              </a:path>
            </a:pathLst>
          </a:custGeom>
        </p:spPr>
      </p:pic>
      <p:pic>
        <p:nvPicPr>
          <p:cNvPr id="14" name="图形 3">
            <a:extLst>
              <a:ext uri="{FF2B5EF4-FFF2-40B4-BE49-F238E27FC236}">
                <a16:creationId xmlns:a16="http://schemas.microsoft.com/office/drawing/2014/main" id="{9BDD51AB-1C8D-4BD4-A59E-AC0E32A4C365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7322773" y="3920454"/>
            <a:ext cx="945143" cy="945184"/>
          </a:xfrm>
          <a:custGeom>
            <a:avLst/>
            <a:gdLst>
              <a:gd name="connsiteX0" fmla="*/ 159 w 945143"/>
              <a:gd name="connsiteY0" fmla="*/ 394 h 945184"/>
              <a:gd name="connsiteX1" fmla="*/ 945302 w 945143"/>
              <a:gd name="connsiteY1" fmla="*/ 394 h 945184"/>
              <a:gd name="connsiteX2" fmla="*/ 945302 w 945143"/>
              <a:gd name="connsiteY2" fmla="*/ 945578 h 945184"/>
              <a:gd name="connsiteX3" fmla="*/ 159 w 945143"/>
              <a:gd name="connsiteY3" fmla="*/ 945578 h 94518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45143" h="945184">
                <a:moveTo>
                  <a:pt x="159" y="394"/>
                </a:moveTo>
                <a:lnTo>
                  <a:pt x="945302" y="394"/>
                </a:lnTo>
                <a:lnTo>
                  <a:pt x="945302" y="945578"/>
                </a:lnTo>
                <a:lnTo>
                  <a:pt x="159" y="945578"/>
                </a:lnTo>
                <a:close/>
              </a:path>
            </a:pathLst>
          </a:cu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7264B8E6-6D61-41FC-A215-F1EB70C0A09D}"/>
              </a:ext>
            </a:extLst>
          </p:cNvPr>
          <p:cNvSpPr txBox="1"/>
          <p:nvPr/>
        </p:nvSpPr>
        <p:spPr>
          <a:xfrm>
            <a:off x="2270104" y="3195920"/>
            <a:ext cx="17287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pHBLV</a:t>
            </a:r>
            <a:r>
              <a:rPr lang="en-US" altLang="zh-CN" dirty="0"/>
              <a:t> control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401CF787-9E27-42B4-A602-183E79CDD153}"/>
              </a:ext>
            </a:extLst>
          </p:cNvPr>
          <p:cNvSpPr txBox="1"/>
          <p:nvPr/>
        </p:nvSpPr>
        <p:spPr>
          <a:xfrm>
            <a:off x="2501045" y="1081697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Dox</a:t>
            </a:r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634CE29F-FB2C-4BD0-8E4C-B7761F2BDC0A}"/>
              </a:ext>
            </a:extLst>
          </p:cNvPr>
          <p:cNvSpPr txBox="1"/>
          <p:nvPr/>
        </p:nvSpPr>
        <p:spPr>
          <a:xfrm>
            <a:off x="2501045" y="1431430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3-MA</a:t>
            </a:r>
            <a:endParaRPr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549F8DDB-E4C7-46D4-BA78-03060D467667}"/>
              </a:ext>
            </a:extLst>
          </p:cNvPr>
          <p:cNvSpPr txBox="1"/>
          <p:nvPr/>
        </p:nvSpPr>
        <p:spPr>
          <a:xfrm>
            <a:off x="6622253" y="1048234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-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AD737E05-4181-4E24-818E-2E00DADFA907}"/>
              </a:ext>
            </a:extLst>
          </p:cNvPr>
          <p:cNvSpPr txBox="1"/>
          <p:nvPr/>
        </p:nvSpPr>
        <p:spPr>
          <a:xfrm>
            <a:off x="5579971" y="1441949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-</a:t>
            </a:r>
            <a:endParaRPr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A02DA951-0878-420F-8334-5A652FBC730C}"/>
              </a:ext>
            </a:extLst>
          </p:cNvPr>
          <p:cNvSpPr txBox="1"/>
          <p:nvPr/>
        </p:nvSpPr>
        <p:spPr>
          <a:xfrm>
            <a:off x="7655713" y="1072618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+</a:t>
            </a:r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82592975-8DC9-4CD5-80FA-EF55648C7BF4}"/>
              </a:ext>
            </a:extLst>
          </p:cNvPr>
          <p:cNvSpPr txBox="1"/>
          <p:nvPr/>
        </p:nvSpPr>
        <p:spPr>
          <a:xfrm>
            <a:off x="6596664" y="1463030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+</a:t>
            </a:r>
            <a:endParaRPr lang="zh-CN" altLang="en-US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8FFC325E-9211-4CBC-A5D3-13DDFB3AD69C}"/>
              </a:ext>
            </a:extLst>
          </p:cNvPr>
          <p:cNvSpPr txBox="1"/>
          <p:nvPr/>
        </p:nvSpPr>
        <p:spPr>
          <a:xfrm>
            <a:off x="7693096" y="148991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+</a:t>
            </a:r>
            <a:endParaRPr lang="zh-CN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06CFED29-F53C-427A-9F16-2C0145763727}"/>
              </a:ext>
            </a:extLst>
          </p:cNvPr>
          <p:cNvSpPr txBox="1"/>
          <p:nvPr/>
        </p:nvSpPr>
        <p:spPr>
          <a:xfrm>
            <a:off x="5554923" y="1080648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+</a:t>
            </a:r>
            <a:endParaRPr lang="zh-CN" altLang="en-US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6324868C-82AD-42DC-BD50-A4719188CC0E}"/>
              </a:ext>
            </a:extLst>
          </p:cNvPr>
          <p:cNvSpPr txBox="1"/>
          <p:nvPr/>
        </p:nvSpPr>
        <p:spPr>
          <a:xfrm>
            <a:off x="4597145" y="1437629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-</a:t>
            </a:r>
            <a:endParaRPr lang="zh-CN" altLang="en-US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2BDE9266-DA35-498F-B172-D99EE91FA7DF}"/>
              </a:ext>
            </a:extLst>
          </p:cNvPr>
          <p:cNvSpPr txBox="1"/>
          <p:nvPr/>
        </p:nvSpPr>
        <p:spPr>
          <a:xfrm>
            <a:off x="4605612" y="1045360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-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39728153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1629D625-D381-4818-B566-07D0701845C0}"/>
              </a:ext>
            </a:extLst>
          </p:cNvPr>
          <p:cNvSpPr txBox="1"/>
          <p:nvPr/>
        </p:nvSpPr>
        <p:spPr>
          <a:xfrm>
            <a:off x="70386" y="5667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 5E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79B5E18A-4F65-44EB-BBDD-784A57833D8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05812" y="1881187"/>
            <a:ext cx="1394492" cy="144000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D61A9644-06E2-4175-AEA0-501B46782A1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2312" y="1881187"/>
            <a:ext cx="1394492" cy="144000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9EEB5F6E-4AF0-478C-9B03-F47988BF1F4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72262" y="1881187"/>
            <a:ext cx="1394492" cy="1440000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E3C664DF-FCB8-4B45-BE34-AE3A69C6751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2312" y="3719512"/>
            <a:ext cx="1394492" cy="1440000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B11A18CB-B2E7-49C8-9BB9-1F6EFC3E2DA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05812" y="3719512"/>
            <a:ext cx="1394492" cy="1440000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978C7A5C-69E4-4088-BD8A-7743DFEB24A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67287" y="3719512"/>
            <a:ext cx="1394492" cy="1440000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EB9A32A9-A9DD-4552-8DA0-63C965DC984D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67287" y="1881187"/>
            <a:ext cx="1394492" cy="1440000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A8C50DF0-557A-4D70-B663-B5465ABACBD4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81787" y="3724274"/>
            <a:ext cx="1394492" cy="1440000"/>
          </a:xfrm>
          <a:prstGeom prst="rect">
            <a:avLst/>
          </a:prstGeom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id="{08D95EE3-3247-4EF8-811C-CE4447440445}"/>
              </a:ext>
            </a:extLst>
          </p:cNvPr>
          <p:cNvSpPr txBox="1"/>
          <p:nvPr/>
        </p:nvSpPr>
        <p:spPr>
          <a:xfrm>
            <a:off x="1223041" y="2416521"/>
            <a:ext cx="17287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estrin2 shRNA</a:t>
            </a:r>
            <a:endParaRPr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17ECC7CD-A77C-493F-A4D1-145691CE2819}"/>
              </a:ext>
            </a:extLst>
          </p:cNvPr>
          <p:cNvSpPr txBox="1"/>
          <p:nvPr/>
        </p:nvSpPr>
        <p:spPr>
          <a:xfrm>
            <a:off x="1227804" y="4254846"/>
            <a:ext cx="17287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trol shRNA</a:t>
            </a:r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B0C41C14-BBB5-473A-802E-01DAAA4B2E2D}"/>
              </a:ext>
            </a:extLst>
          </p:cNvPr>
          <p:cNvSpPr txBox="1"/>
          <p:nvPr/>
        </p:nvSpPr>
        <p:spPr>
          <a:xfrm>
            <a:off x="1339592" y="1051931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Dox</a:t>
            </a:r>
            <a:endParaRPr lang="zh-CN" altLang="en-US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BB716A39-CFB3-42EC-A52C-EC586D0A5984}"/>
              </a:ext>
            </a:extLst>
          </p:cNvPr>
          <p:cNvSpPr txBox="1"/>
          <p:nvPr/>
        </p:nvSpPr>
        <p:spPr>
          <a:xfrm>
            <a:off x="1223041" y="1423301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-PBA</a:t>
            </a:r>
            <a:endParaRPr lang="zh-CN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C3F3A99C-2497-493A-B771-6F8B1FE5E928}"/>
              </a:ext>
            </a:extLst>
          </p:cNvPr>
          <p:cNvSpPr txBox="1"/>
          <p:nvPr/>
        </p:nvSpPr>
        <p:spPr>
          <a:xfrm>
            <a:off x="7223384" y="1051931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-</a:t>
            </a:r>
            <a:endParaRPr lang="zh-CN" altLang="en-US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4D2BDE14-4447-4BD1-90EC-70BA898B0B5F}"/>
              </a:ext>
            </a:extLst>
          </p:cNvPr>
          <p:cNvSpPr txBox="1"/>
          <p:nvPr/>
        </p:nvSpPr>
        <p:spPr>
          <a:xfrm>
            <a:off x="5512236" y="1445647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-</a:t>
            </a:r>
            <a:endParaRPr lang="zh-CN" altLang="en-US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47FBA8B8-A542-4662-B9AA-582FB19B3F26}"/>
              </a:ext>
            </a:extLst>
          </p:cNvPr>
          <p:cNvSpPr txBox="1"/>
          <p:nvPr/>
        </p:nvSpPr>
        <p:spPr>
          <a:xfrm>
            <a:off x="8942647" y="1076315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+</a:t>
            </a:r>
            <a:endParaRPr lang="zh-CN" altLang="en-US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DBD4DFB7-2B50-4733-90A9-87449C708AEB}"/>
              </a:ext>
            </a:extLst>
          </p:cNvPr>
          <p:cNvSpPr txBox="1"/>
          <p:nvPr/>
        </p:nvSpPr>
        <p:spPr>
          <a:xfrm>
            <a:off x="7189330" y="1509060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+</a:t>
            </a:r>
            <a:endParaRPr lang="zh-CN" altLang="en-US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7CCE5615-9B0C-4DF4-953A-C75FD92140BE}"/>
              </a:ext>
            </a:extLst>
          </p:cNvPr>
          <p:cNvSpPr txBox="1"/>
          <p:nvPr/>
        </p:nvSpPr>
        <p:spPr>
          <a:xfrm>
            <a:off x="8980030" y="1493610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+</a:t>
            </a:r>
            <a:endParaRPr lang="zh-CN" altLang="en-US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2BC67095-7A2E-42D7-927E-62E641C0A787}"/>
              </a:ext>
            </a:extLst>
          </p:cNvPr>
          <p:cNvSpPr txBox="1"/>
          <p:nvPr/>
        </p:nvSpPr>
        <p:spPr>
          <a:xfrm>
            <a:off x="5504122" y="1042011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+</a:t>
            </a:r>
            <a:endParaRPr lang="zh-CN" altLang="en-US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756D6A0E-073E-473B-B656-FB0431BC3774}"/>
              </a:ext>
            </a:extLst>
          </p:cNvPr>
          <p:cNvSpPr txBox="1"/>
          <p:nvPr/>
        </p:nvSpPr>
        <p:spPr>
          <a:xfrm>
            <a:off x="3835142" y="1509060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-</a:t>
            </a:r>
            <a:endParaRPr lang="zh-CN" altLang="en-US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7ED4A6CB-82A0-48EF-B6CF-7D8D313D7D0C}"/>
              </a:ext>
            </a:extLst>
          </p:cNvPr>
          <p:cNvSpPr txBox="1"/>
          <p:nvPr/>
        </p:nvSpPr>
        <p:spPr>
          <a:xfrm>
            <a:off x="3835142" y="1116791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-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1917850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7</TotalTime>
  <Words>77</Words>
  <Application>Microsoft Office PowerPoint</Application>
  <PresentationFormat>宽屏</PresentationFormat>
  <Paragraphs>61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9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汤 臻</dc:creator>
  <cp:lastModifiedBy>汤 臻</cp:lastModifiedBy>
  <cp:revision>9</cp:revision>
  <dcterms:created xsi:type="dcterms:W3CDTF">2021-06-15T01:43:45Z</dcterms:created>
  <dcterms:modified xsi:type="dcterms:W3CDTF">2021-06-15T02:53:08Z</dcterms:modified>
</cp:coreProperties>
</file>